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70" r:id="rId2"/>
  </p:sldIdLst>
  <p:sldSz cx="6858000" cy="9906000" type="A4"/>
  <p:notesSz cx="6797675" cy="9926638"/>
  <p:defaultTextStyle>
    <a:defPPr>
      <a:defRPr lang="en-US"/>
    </a:defPPr>
    <a:lvl1pPr marL="0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FF7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0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Papers\Fusarium%20in%20planta%20transcriptome\Fom%20transcriptome%20paper%20data%20(Recovered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Papers\Fusarium%20in%20planta%20transcriptome\Fom%20transcriptome%20paper%20data%20(Recovered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Papers\Fusarium%20in%20planta%20transcriptome\Fom%20transcriptome%20paper%20data%20(Recovered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Papers\Fusarium%20in%20planta%20transcriptome\Fom%20transcriptome%20paper%20data%20(Recovered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L$2</c:f>
              <c:strCache>
                <c:ptCount val="1"/>
                <c:pt idx="0">
                  <c:v>pvalu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4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4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4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0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rgbClr val="FF0000"/>
                </a:solidFill>
                <a:round/>
              </a:ln>
              <a:effectLst/>
            </c:spPr>
          </c:dPt>
          <c:dPt>
            <c:idx val="10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xVal>
            <c:numRef>
              <c:f>Sheet1!$K$3:$K$119</c:f>
              <c:numCache>
                <c:formatCode>General</c:formatCode>
                <c:ptCount val="117"/>
                <c:pt idx="0">
                  <c:v>18.5530799425797</c:v>
                </c:pt>
                <c:pt idx="1">
                  <c:v>17.383039296631601</c:v>
                </c:pt>
                <c:pt idx="2">
                  <c:v>17.289007822309401</c:v>
                </c:pt>
                <c:pt idx="3">
                  <c:v>17.034926923375298</c:v>
                </c:pt>
                <c:pt idx="4">
                  <c:v>16.964850018120298</c:v>
                </c:pt>
                <c:pt idx="5">
                  <c:v>16.186718648323101</c:v>
                </c:pt>
                <c:pt idx="6">
                  <c:v>16.080585206068498</c:v>
                </c:pt>
                <c:pt idx="7">
                  <c:v>15.973094935118</c:v>
                </c:pt>
                <c:pt idx="8">
                  <c:v>15.2374739256932</c:v>
                </c:pt>
                <c:pt idx="9">
                  <c:v>14.2681936987968</c:v>
                </c:pt>
                <c:pt idx="10">
                  <c:v>14.137195426022201</c:v>
                </c:pt>
                <c:pt idx="11">
                  <c:v>13.8651479581481</c:v>
                </c:pt>
                <c:pt idx="12">
                  <c:v>13.558301873906199</c:v>
                </c:pt>
                <c:pt idx="13">
                  <c:v>13.5409921672702</c:v>
                </c:pt>
                <c:pt idx="14">
                  <c:v>13.519957659231499</c:v>
                </c:pt>
                <c:pt idx="15">
                  <c:v>13.4973465596757</c:v>
                </c:pt>
                <c:pt idx="16">
                  <c:v>13.0958144217396</c:v>
                </c:pt>
                <c:pt idx="17">
                  <c:v>12.880836850174299</c:v>
                </c:pt>
                <c:pt idx="18">
                  <c:v>12.1169815673372</c:v>
                </c:pt>
                <c:pt idx="19">
                  <c:v>11.9868102149071</c:v>
                </c:pt>
                <c:pt idx="20">
                  <c:v>11.528354517295501</c:v>
                </c:pt>
                <c:pt idx="21">
                  <c:v>11.1084754697474</c:v>
                </c:pt>
                <c:pt idx="22">
                  <c:v>11.0751618425372</c:v>
                </c:pt>
                <c:pt idx="23">
                  <c:v>10.9516457587729</c:v>
                </c:pt>
                <c:pt idx="24">
                  <c:v>10.932407157915</c:v>
                </c:pt>
                <c:pt idx="25">
                  <c:v>10.603929468687101</c:v>
                </c:pt>
                <c:pt idx="26">
                  <c:v>10.575883071914101</c:v>
                </c:pt>
                <c:pt idx="27">
                  <c:v>10.421344904999099</c:v>
                </c:pt>
                <c:pt idx="28">
                  <c:v>10.3363619709557</c:v>
                </c:pt>
                <c:pt idx="29">
                  <c:v>10.290510409903799</c:v>
                </c:pt>
                <c:pt idx="30">
                  <c:v>10.131715607265701</c:v>
                </c:pt>
                <c:pt idx="31">
                  <c:v>9.9751249918996905</c:v>
                </c:pt>
                <c:pt idx="32">
                  <c:v>9.9637055748960606</c:v>
                </c:pt>
                <c:pt idx="33">
                  <c:v>9.9007805008578096</c:v>
                </c:pt>
                <c:pt idx="34">
                  <c:v>9.8910459342823707</c:v>
                </c:pt>
                <c:pt idx="35">
                  <c:v>9.8823989523054596</c:v>
                </c:pt>
                <c:pt idx="36">
                  <c:v>9.8718463672394794</c:v>
                </c:pt>
                <c:pt idx="37">
                  <c:v>9.8540728621847808</c:v>
                </c:pt>
                <c:pt idx="38">
                  <c:v>9.6252959861133505</c:v>
                </c:pt>
                <c:pt idx="39">
                  <c:v>9.5949131607317497</c:v>
                </c:pt>
                <c:pt idx="40">
                  <c:v>9.5630388575106604</c:v>
                </c:pt>
                <c:pt idx="41">
                  <c:v>9.4824956754624097</c:v>
                </c:pt>
                <c:pt idx="42">
                  <c:v>9.2263171168977092</c:v>
                </c:pt>
                <c:pt idx="43">
                  <c:v>9.2112776003176098</c:v>
                </c:pt>
                <c:pt idx="44">
                  <c:v>9.1388841808461496</c:v>
                </c:pt>
                <c:pt idx="45">
                  <c:v>8.9879962105674291</c:v>
                </c:pt>
                <c:pt idx="46">
                  <c:v>8.8580576998469205</c:v>
                </c:pt>
                <c:pt idx="47">
                  <c:v>8.8238436706808301</c:v>
                </c:pt>
                <c:pt idx="48">
                  <c:v>8.7470982538184003</c:v>
                </c:pt>
                <c:pt idx="49">
                  <c:v>8.6717735741380508</c:v>
                </c:pt>
                <c:pt idx="50">
                  <c:v>8.3262952082878208</c:v>
                </c:pt>
                <c:pt idx="51">
                  <c:v>8.0894255476917003</c:v>
                </c:pt>
                <c:pt idx="52">
                  <c:v>7.9873790326394403</c:v>
                </c:pt>
                <c:pt idx="53">
                  <c:v>7.8157515225029597</c:v>
                </c:pt>
                <c:pt idx="54">
                  <c:v>7.8744646163849099</c:v>
                </c:pt>
                <c:pt idx="55">
                  <c:v>7.7724786365345304</c:v>
                </c:pt>
                <c:pt idx="56">
                  <c:v>7.57833644935012</c:v>
                </c:pt>
                <c:pt idx="57">
                  <c:v>7.5061883920141099</c:v>
                </c:pt>
                <c:pt idx="58">
                  <c:v>7.40446402152714</c:v>
                </c:pt>
                <c:pt idx="59">
                  <c:v>7.4008219582936299</c:v>
                </c:pt>
                <c:pt idx="60">
                  <c:v>7.2011349054844596</c:v>
                </c:pt>
                <c:pt idx="61">
                  <c:v>6.8079499953001399</c:v>
                </c:pt>
                <c:pt idx="62">
                  <c:v>6.6981921936985502</c:v>
                </c:pt>
                <c:pt idx="63">
                  <c:v>6.6548007623075298</c:v>
                </c:pt>
                <c:pt idx="64">
                  <c:v>6.5861093572065998</c:v>
                </c:pt>
                <c:pt idx="65">
                  <c:v>6.5573500622964298</c:v>
                </c:pt>
                <c:pt idx="66">
                  <c:v>6.3953973340621699</c:v>
                </c:pt>
                <c:pt idx="67">
                  <c:v>6.2804875883953803</c:v>
                </c:pt>
                <c:pt idx="68">
                  <c:v>6.0344282349180904</c:v>
                </c:pt>
                <c:pt idx="69">
                  <c:v>5.9909625040855898</c:v>
                </c:pt>
                <c:pt idx="70">
                  <c:v>5.9399964708371602</c:v>
                </c:pt>
                <c:pt idx="71">
                  <c:v>5.8850793803159096</c:v>
                </c:pt>
                <c:pt idx="72">
                  <c:v>5.6869542780909299</c:v>
                </c:pt>
                <c:pt idx="73">
                  <c:v>5.6331265441835701</c:v>
                </c:pt>
                <c:pt idx="74">
                  <c:v>5.5942358582710403</c:v>
                </c:pt>
                <c:pt idx="75">
                  <c:v>5.5221354003934904</c:v>
                </c:pt>
                <c:pt idx="76">
                  <c:v>5.2995416644010804</c:v>
                </c:pt>
                <c:pt idx="77">
                  <c:v>5.18923898797033</c:v>
                </c:pt>
                <c:pt idx="78">
                  <c:v>5.0069486443642504</c:v>
                </c:pt>
                <c:pt idx="79">
                  <c:v>4.9178267077791897</c:v>
                </c:pt>
                <c:pt idx="80">
                  <c:v>4.7332975277565801</c:v>
                </c:pt>
                <c:pt idx="81">
                  <c:v>4.6309217493800396</c:v>
                </c:pt>
                <c:pt idx="82">
                  <c:v>4.6178949291487799</c:v>
                </c:pt>
                <c:pt idx="83">
                  <c:v>4.6162815175361001</c:v>
                </c:pt>
                <c:pt idx="84">
                  <c:v>4.56903520162217</c:v>
                </c:pt>
                <c:pt idx="85">
                  <c:v>4.55404976514561</c:v>
                </c:pt>
                <c:pt idx="86">
                  <c:v>4.4175113773017598</c:v>
                </c:pt>
                <c:pt idx="87">
                  <c:v>4.35881950249337</c:v>
                </c:pt>
                <c:pt idx="88">
                  <c:v>4.3566110057044103</c:v>
                </c:pt>
                <c:pt idx="89">
                  <c:v>4.2758132212717097</c:v>
                </c:pt>
                <c:pt idx="90">
                  <c:v>4.2571149515675097</c:v>
                </c:pt>
                <c:pt idx="91">
                  <c:v>4.1771952605919704</c:v>
                </c:pt>
                <c:pt idx="92">
                  <c:v>4.0264457673427598</c:v>
                </c:pt>
                <c:pt idx="93">
                  <c:v>3.9639755151462901</c:v>
                </c:pt>
                <c:pt idx="94">
                  <c:v>3.8719007366459599</c:v>
                </c:pt>
                <c:pt idx="95">
                  <c:v>3.7285273097087499</c:v>
                </c:pt>
                <c:pt idx="96">
                  <c:v>3.5143371472909801</c:v>
                </c:pt>
                <c:pt idx="97">
                  <c:v>3.2866941972051502</c:v>
                </c:pt>
                <c:pt idx="98">
                  <c:v>3.2038600998348898</c:v>
                </c:pt>
                <c:pt idx="99">
                  <c:v>3.1990697625975799</c:v>
                </c:pt>
                <c:pt idx="100">
                  <c:v>3.1777512184075598</c:v>
                </c:pt>
                <c:pt idx="101">
                  <c:v>3.0774948182052499</c:v>
                </c:pt>
                <c:pt idx="102">
                  <c:v>2.98399796444598</c:v>
                </c:pt>
                <c:pt idx="103">
                  <c:v>2.9561742711244698</c:v>
                </c:pt>
                <c:pt idx="104">
                  <c:v>2.80612632326722</c:v>
                </c:pt>
                <c:pt idx="105">
                  <c:v>2.5835884662403901</c:v>
                </c:pt>
                <c:pt idx="106">
                  <c:v>2.5372832765455802</c:v>
                </c:pt>
                <c:pt idx="107">
                  <c:v>2.49020501792159</c:v>
                </c:pt>
                <c:pt idx="108">
                  <c:v>2.4670629577137202</c:v>
                </c:pt>
                <c:pt idx="109">
                  <c:v>2.37455589842543</c:v>
                </c:pt>
                <c:pt idx="110">
                  <c:v>2.2430340903122099</c:v>
                </c:pt>
                <c:pt idx="111">
                  <c:v>2.2166161563127198</c:v>
                </c:pt>
                <c:pt idx="112">
                  <c:v>2.0044701265152698</c:v>
                </c:pt>
                <c:pt idx="113">
                  <c:v>1.9767448088794799</c:v>
                </c:pt>
                <c:pt idx="114">
                  <c:v>1.90675121752482</c:v>
                </c:pt>
                <c:pt idx="115">
                  <c:v>1.8540345826525</c:v>
                </c:pt>
                <c:pt idx="116">
                  <c:v>1.4208759270193301</c:v>
                </c:pt>
              </c:numCache>
            </c:numRef>
          </c:xVal>
          <c:yVal>
            <c:numRef>
              <c:f>Sheet1!$L$3:$L$119</c:f>
              <c:numCache>
                <c:formatCode>General</c:formatCode>
                <c:ptCount val="117"/>
                <c:pt idx="0">
                  <c:v>1.7400000000000001E-44</c:v>
                </c:pt>
                <c:pt idx="1">
                  <c:v>1.3800000000000001E-37</c:v>
                </c:pt>
                <c:pt idx="2">
                  <c:v>1.15E-46</c:v>
                </c:pt>
                <c:pt idx="3">
                  <c:v>3.06E-37</c:v>
                </c:pt>
                <c:pt idx="4">
                  <c:v>2.8199999999999999E-35</c:v>
                </c:pt>
                <c:pt idx="5">
                  <c:v>7.22E-28</c:v>
                </c:pt>
                <c:pt idx="6">
                  <c:v>3.8700000000000002E-31</c:v>
                </c:pt>
                <c:pt idx="7">
                  <c:v>5.0099999999999996E-25</c:v>
                </c:pt>
                <c:pt idx="8">
                  <c:v>2.3099999999999998E-58</c:v>
                </c:pt>
                <c:pt idx="9">
                  <c:v>1.3800000000000001E-26</c:v>
                </c:pt>
                <c:pt idx="10">
                  <c:v>7.2800000000000003E-8</c:v>
                </c:pt>
                <c:pt idx="11">
                  <c:v>6.5600000000000002E-35</c:v>
                </c:pt>
                <c:pt idx="12">
                  <c:v>4.5799999999999998E-53</c:v>
                </c:pt>
                <c:pt idx="13">
                  <c:v>4.8599999999999998E-10</c:v>
                </c:pt>
                <c:pt idx="14">
                  <c:v>1.15E-38</c:v>
                </c:pt>
                <c:pt idx="15">
                  <c:v>2.6599999999999999E-67</c:v>
                </c:pt>
                <c:pt idx="16">
                  <c:v>2.74E-58</c:v>
                </c:pt>
                <c:pt idx="17">
                  <c:v>5.5900000000000001E-34</c:v>
                </c:pt>
                <c:pt idx="18">
                  <c:v>2.2E-55</c:v>
                </c:pt>
                <c:pt idx="19">
                  <c:v>1.2800000000000001E-30</c:v>
                </c:pt>
                <c:pt idx="20">
                  <c:v>8.5300000000000001E-33</c:v>
                </c:pt>
                <c:pt idx="21">
                  <c:v>5.3900000000000002E-33</c:v>
                </c:pt>
                <c:pt idx="22">
                  <c:v>1.8499999999999999E-52</c:v>
                </c:pt>
                <c:pt idx="23">
                  <c:v>5.6599999999999998E-37</c:v>
                </c:pt>
                <c:pt idx="24">
                  <c:v>6.7800000000000001E-25</c:v>
                </c:pt>
                <c:pt idx="25">
                  <c:v>3.78E-44</c:v>
                </c:pt>
                <c:pt idx="26">
                  <c:v>2.1E-18</c:v>
                </c:pt>
                <c:pt idx="27">
                  <c:v>9.4700000000000006E-11</c:v>
                </c:pt>
                <c:pt idx="28">
                  <c:v>3.0600000000000001E-28</c:v>
                </c:pt>
                <c:pt idx="29">
                  <c:v>1.4299999999999999E-31</c:v>
                </c:pt>
                <c:pt idx="30">
                  <c:v>2.0199999999999999E-11</c:v>
                </c:pt>
                <c:pt idx="31">
                  <c:v>5.18E-24</c:v>
                </c:pt>
                <c:pt idx="32">
                  <c:v>3.09E-30</c:v>
                </c:pt>
                <c:pt idx="33">
                  <c:v>1.73E-31</c:v>
                </c:pt>
                <c:pt idx="34">
                  <c:v>3.17E-29</c:v>
                </c:pt>
                <c:pt idx="35">
                  <c:v>1.0599999999999999E-24</c:v>
                </c:pt>
                <c:pt idx="36">
                  <c:v>8.3199999999999996E-29</c:v>
                </c:pt>
                <c:pt idx="37">
                  <c:v>1.0999999999999999E-34</c:v>
                </c:pt>
                <c:pt idx="38">
                  <c:v>4.7999999999999996E-24</c:v>
                </c:pt>
                <c:pt idx="39">
                  <c:v>2.5000000000000001E-23</c:v>
                </c:pt>
                <c:pt idx="40">
                  <c:v>7.9700000000000008E-37</c:v>
                </c:pt>
                <c:pt idx="41">
                  <c:v>4.0600000000000003E-27</c:v>
                </c:pt>
                <c:pt idx="42">
                  <c:v>4.5599999999999997E-21</c:v>
                </c:pt>
                <c:pt idx="43">
                  <c:v>4.36E-12</c:v>
                </c:pt>
                <c:pt idx="44">
                  <c:v>6.0900000000000002E-30</c:v>
                </c:pt>
                <c:pt idx="45">
                  <c:v>9.1100000000000005E-37</c:v>
                </c:pt>
                <c:pt idx="46">
                  <c:v>3.7200000000000002E-30</c:v>
                </c:pt>
                <c:pt idx="47">
                  <c:v>7.9800000000000001E-19</c:v>
                </c:pt>
                <c:pt idx="48">
                  <c:v>1.29E-24</c:v>
                </c:pt>
                <c:pt idx="49">
                  <c:v>3.4299999999999999E-22</c:v>
                </c:pt>
                <c:pt idx="50">
                  <c:v>8.0299999999999998E-31</c:v>
                </c:pt>
                <c:pt idx="51">
                  <c:v>5.4800000000000002E-28</c:v>
                </c:pt>
                <c:pt idx="52">
                  <c:v>3.2200000000000001E-24</c:v>
                </c:pt>
                <c:pt idx="53">
                  <c:v>1.29E-30</c:v>
                </c:pt>
                <c:pt idx="54">
                  <c:v>8.5461907345903698E-38</c:v>
                </c:pt>
                <c:pt idx="55">
                  <c:v>2.2600000000000001E-28</c:v>
                </c:pt>
                <c:pt idx="56">
                  <c:v>4.0300000000000002E-27</c:v>
                </c:pt>
                <c:pt idx="57">
                  <c:v>4.3900000000000002E-27</c:v>
                </c:pt>
                <c:pt idx="58">
                  <c:v>2.3699999999999999E-24</c:v>
                </c:pt>
                <c:pt idx="59">
                  <c:v>1.15E-27</c:v>
                </c:pt>
                <c:pt idx="60">
                  <c:v>3.5300000000000001E-25</c:v>
                </c:pt>
                <c:pt idx="61">
                  <c:v>2.8699999999999999E-8</c:v>
                </c:pt>
                <c:pt idx="62">
                  <c:v>1.9400000000000001E-14</c:v>
                </c:pt>
                <c:pt idx="63">
                  <c:v>6.4300000000000001E-14</c:v>
                </c:pt>
                <c:pt idx="64">
                  <c:v>4.3E-27</c:v>
                </c:pt>
                <c:pt idx="65">
                  <c:v>2.1599999999999999E-13</c:v>
                </c:pt>
                <c:pt idx="66">
                  <c:v>2.0400000000000001E-21</c:v>
                </c:pt>
                <c:pt idx="67">
                  <c:v>2.7099999999999998E-26</c:v>
                </c:pt>
                <c:pt idx="68">
                  <c:v>1.41E-17</c:v>
                </c:pt>
                <c:pt idx="69">
                  <c:v>2.1199999999999999E-21</c:v>
                </c:pt>
                <c:pt idx="70">
                  <c:v>1.9200000000000001E-25</c:v>
                </c:pt>
                <c:pt idx="71">
                  <c:v>5.0199999999999997E-14</c:v>
                </c:pt>
                <c:pt idx="72">
                  <c:v>6.1700000000000005E-14</c:v>
                </c:pt>
                <c:pt idx="73">
                  <c:v>8.8299999999999996E-24</c:v>
                </c:pt>
                <c:pt idx="74">
                  <c:v>2.2999999999999999E-15</c:v>
                </c:pt>
                <c:pt idx="75">
                  <c:v>1.7700000000000001E-20</c:v>
                </c:pt>
                <c:pt idx="76">
                  <c:v>1.15E-21</c:v>
                </c:pt>
                <c:pt idx="77">
                  <c:v>8.4199999999999997E-22</c:v>
                </c:pt>
                <c:pt idx="78">
                  <c:v>4.0300000000000001E-18</c:v>
                </c:pt>
                <c:pt idx="79">
                  <c:v>1.59E-16</c:v>
                </c:pt>
                <c:pt idx="80">
                  <c:v>1.8399999999999999E-15</c:v>
                </c:pt>
                <c:pt idx="81">
                  <c:v>3.7499999999999998E-16</c:v>
                </c:pt>
                <c:pt idx="82">
                  <c:v>3.0899999999999999E-16</c:v>
                </c:pt>
                <c:pt idx="83">
                  <c:v>2.54E-18</c:v>
                </c:pt>
                <c:pt idx="84">
                  <c:v>6.7500000000000005E-10</c:v>
                </c:pt>
                <c:pt idx="85">
                  <c:v>1.2800000000000001E-16</c:v>
                </c:pt>
                <c:pt idx="86">
                  <c:v>2.3600000000000001E-15</c:v>
                </c:pt>
                <c:pt idx="87">
                  <c:v>5.3900000000000003E-12</c:v>
                </c:pt>
                <c:pt idx="88">
                  <c:v>1.88E-16</c:v>
                </c:pt>
                <c:pt idx="89">
                  <c:v>5.1100000000000004E-13</c:v>
                </c:pt>
                <c:pt idx="90">
                  <c:v>8.2399999999999997E-9</c:v>
                </c:pt>
                <c:pt idx="91">
                  <c:v>2.18E-10</c:v>
                </c:pt>
                <c:pt idx="92">
                  <c:v>8.7999999999999997E-12</c:v>
                </c:pt>
                <c:pt idx="93">
                  <c:v>3.67E-13</c:v>
                </c:pt>
                <c:pt idx="94">
                  <c:v>3.2300000000000002E-10</c:v>
                </c:pt>
                <c:pt idx="95">
                  <c:v>4.4000000000000003E-11</c:v>
                </c:pt>
                <c:pt idx="96">
                  <c:v>8.2999999999999998E-12</c:v>
                </c:pt>
                <c:pt idx="97">
                  <c:v>4.8E-9</c:v>
                </c:pt>
                <c:pt idx="98">
                  <c:v>1.6899999999999999E-8</c:v>
                </c:pt>
                <c:pt idx="99">
                  <c:v>2.8000000000000002E-10</c:v>
                </c:pt>
                <c:pt idx="100">
                  <c:v>5.0400000000000002E-11</c:v>
                </c:pt>
                <c:pt idx="101">
                  <c:v>1.01E-9</c:v>
                </c:pt>
                <c:pt idx="102">
                  <c:v>1.02E-8</c:v>
                </c:pt>
                <c:pt idx="103">
                  <c:v>3.7599999999999999E-10</c:v>
                </c:pt>
                <c:pt idx="104">
                  <c:v>5.2100000000000003E-8</c:v>
                </c:pt>
                <c:pt idx="105">
                  <c:v>2.9000000000000002E-8</c:v>
                </c:pt>
                <c:pt idx="106">
                  <c:v>3.57E-4</c:v>
                </c:pt>
                <c:pt idx="107">
                  <c:v>5.37E-7</c:v>
                </c:pt>
                <c:pt idx="108">
                  <c:v>1.59E-5</c:v>
                </c:pt>
                <c:pt idx="109">
                  <c:v>1.61E-6</c:v>
                </c:pt>
                <c:pt idx="110">
                  <c:v>1.2099999999999999E-5</c:v>
                </c:pt>
                <c:pt idx="111">
                  <c:v>6.1799999999999995E-4</c:v>
                </c:pt>
                <c:pt idx="112">
                  <c:v>7.5299999999999998E-4</c:v>
                </c:pt>
                <c:pt idx="113">
                  <c:v>6.3099999999999997E-6</c:v>
                </c:pt>
                <c:pt idx="114">
                  <c:v>9.5399999999999999E-4</c:v>
                </c:pt>
                <c:pt idx="115">
                  <c:v>8.1899999999999996E-4</c:v>
                </c:pt>
                <c:pt idx="116">
                  <c:v>6.5900000000000004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620888"/>
        <c:axId val="180427896"/>
      </c:scatterChart>
      <c:valAx>
        <c:axId val="180620888"/>
        <c:scaling>
          <c:orientation val="minMax"/>
        </c:scaling>
        <c:delete val="0"/>
        <c:axPos val="t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427896"/>
        <c:crosses val="autoZero"/>
        <c:crossBetween val="midCat"/>
        <c:majorUnit val="2"/>
      </c:valAx>
      <c:valAx>
        <c:axId val="180427896"/>
        <c:scaling>
          <c:logBase val="10"/>
          <c:orientation val="maxMin"/>
          <c:min val="1.0000000000000039E-67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620888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T$2</c:f>
              <c:strCache>
                <c:ptCount val="1"/>
                <c:pt idx="0">
                  <c:v>pvalu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xVal>
            <c:numRef>
              <c:f>Sheet1!$S$3:$S$109</c:f>
              <c:numCache>
                <c:formatCode>General</c:formatCode>
                <c:ptCount val="107"/>
                <c:pt idx="0">
                  <c:v>18.088638249720201</c:v>
                </c:pt>
                <c:pt idx="1">
                  <c:v>17.304765219396</c:v>
                </c:pt>
                <c:pt idx="2">
                  <c:v>17.2286602859865</c:v>
                </c:pt>
                <c:pt idx="3">
                  <c:v>17.1476163548007</c:v>
                </c:pt>
                <c:pt idx="4">
                  <c:v>16.817793814795799</c:v>
                </c:pt>
                <c:pt idx="5">
                  <c:v>16.414256164400001</c:v>
                </c:pt>
                <c:pt idx="6">
                  <c:v>15.949997129935101</c:v>
                </c:pt>
                <c:pt idx="7">
                  <c:v>15.137865863525301</c:v>
                </c:pt>
                <c:pt idx="8">
                  <c:v>14.493100207835701</c:v>
                </c:pt>
                <c:pt idx="9">
                  <c:v>14.0109146993937</c:v>
                </c:pt>
                <c:pt idx="10">
                  <c:v>13.350697804752601</c:v>
                </c:pt>
                <c:pt idx="11">
                  <c:v>13.048329413255299</c:v>
                </c:pt>
                <c:pt idx="12">
                  <c:v>12.893432857166299</c:v>
                </c:pt>
                <c:pt idx="13">
                  <c:v>12.832143935031199</c:v>
                </c:pt>
                <c:pt idx="14">
                  <c:v>12.5186860461432</c:v>
                </c:pt>
                <c:pt idx="15">
                  <c:v>12.227968844547201</c:v>
                </c:pt>
                <c:pt idx="16">
                  <c:v>12.1966253888408</c:v>
                </c:pt>
                <c:pt idx="17">
                  <c:v>11.846936407253001</c:v>
                </c:pt>
                <c:pt idx="18">
                  <c:v>11.3501613928425</c:v>
                </c:pt>
                <c:pt idx="19">
                  <c:v>11.312106756907999</c:v>
                </c:pt>
                <c:pt idx="20">
                  <c:v>11.173333153805601</c:v>
                </c:pt>
                <c:pt idx="21">
                  <c:v>11.017742420012199</c:v>
                </c:pt>
                <c:pt idx="22">
                  <c:v>10.8517313111735</c:v>
                </c:pt>
                <c:pt idx="23">
                  <c:v>10.578359241507099</c:v>
                </c:pt>
                <c:pt idx="24">
                  <c:v>10.466315661016701</c:v>
                </c:pt>
                <c:pt idx="25">
                  <c:v>10.1430673587064</c:v>
                </c:pt>
                <c:pt idx="26">
                  <c:v>10.121441918535201</c:v>
                </c:pt>
                <c:pt idx="27">
                  <c:v>10.1075216958134</c:v>
                </c:pt>
                <c:pt idx="28">
                  <c:v>9.61626747090836</c:v>
                </c:pt>
                <c:pt idx="29">
                  <c:v>9.6063063050622493</c:v>
                </c:pt>
                <c:pt idx="30">
                  <c:v>9.4389406861133995</c:v>
                </c:pt>
                <c:pt idx="31">
                  <c:v>9.3221166663629393</c:v>
                </c:pt>
                <c:pt idx="32">
                  <c:v>8.5853036861622094</c:v>
                </c:pt>
                <c:pt idx="33">
                  <c:v>8.3207989903221797</c:v>
                </c:pt>
                <c:pt idx="34">
                  <c:v>7.8221978885242898</c:v>
                </c:pt>
                <c:pt idx="35">
                  <c:v>7.7105358827673296</c:v>
                </c:pt>
                <c:pt idx="36">
                  <c:v>7.6879602308906803</c:v>
                </c:pt>
                <c:pt idx="37">
                  <c:v>7.4873715229303102</c:v>
                </c:pt>
                <c:pt idx="38">
                  <c:v>7.4827881892858699</c:v>
                </c:pt>
                <c:pt idx="39">
                  <c:v>7.45186232181356</c:v>
                </c:pt>
                <c:pt idx="40">
                  <c:v>6.6049410636827801</c:v>
                </c:pt>
                <c:pt idx="41">
                  <c:v>6.3418456829045899</c:v>
                </c:pt>
                <c:pt idx="42">
                  <c:v>6.1649387018555704</c:v>
                </c:pt>
                <c:pt idx="43">
                  <c:v>6.0129941276171301</c:v>
                </c:pt>
                <c:pt idx="44">
                  <c:v>5.9335109589468704</c:v>
                </c:pt>
                <c:pt idx="45">
                  <c:v>5.8146576341069203</c:v>
                </c:pt>
                <c:pt idx="46">
                  <c:v>5.7501910001680097</c:v>
                </c:pt>
                <c:pt idx="47">
                  <c:v>5.7278327796170103</c:v>
                </c:pt>
                <c:pt idx="48">
                  <c:v>5.7113399432282002</c:v>
                </c:pt>
                <c:pt idx="49">
                  <c:v>5.5976477669419902</c:v>
                </c:pt>
                <c:pt idx="50">
                  <c:v>5.5530411377907498</c:v>
                </c:pt>
                <c:pt idx="51">
                  <c:v>5.4477204374334498</c:v>
                </c:pt>
                <c:pt idx="52">
                  <c:v>5.3740547838983197</c:v>
                </c:pt>
                <c:pt idx="53">
                  <c:v>5.2553878689879596</c:v>
                </c:pt>
                <c:pt idx="54">
                  <c:v>5.1723290874014003</c:v>
                </c:pt>
                <c:pt idx="55">
                  <c:v>5.0563029942689699</c:v>
                </c:pt>
                <c:pt idx="56">
                  <c:v>5.0420638970115901</c:v>
                </c:pt>
                <c:pt idx="57">
                  <c:v>4.9998196461025399</c:v>
                </c:pt>
                <c:pt idx="58">
                  <c:v>4.9769609350435502</c:v>
                </c:pt>
                <c:pt idx="59">
                  <c:v>4.9753563007818604</c:v>
                </c:pt>
                <c:pt idx="60">
                  <c:v>4.9550163105518701</c:v>
                </c:pt>
                <c:pt idx="61">
                  <c:v>4.7795438000320498</c:v>
                </c:pt>
                <c:pt idx="62">
                  <c:v>4.6732125359141197</c:v>
                </c:pt>
                <c:pt idx="63">
                  <c:v>4.6630097255486698</c:v>
                </c:pt>
                <c:pt idx="64">
                  <c:v>4.6617373853011301</c:v>
                </c:pt>
                <c:pt idx="65">
                  <c:v>4.6207385476879299</c:v>
                </c:pt>
                <c:pt idx="66">
                  <c:v>4.5555107534628601</c:v>
                </c:pt>
                <c:pt idx="67">
                  <c:v>4.4992623019732703</c:v>
                </c:pt>
                <c:pt idx="68">
                  <c:v>4.4004344637304902</c:v>
                </c:pt>
                <c:pt idx="69">
                  <c:v>4.39975167089605</c:v>
                </c:pt>
                <c:pt idx="70">
                  <c:v>4.3288486987626698</c:v>
                </c:pt>
                <c:pt idx="71">
                  <c:v>4.3043352140292503</c:v>
                </c:pt>
                <c:pt idx="72">
                  <c:v>4.2757099352085799</c:v>
                </c:pt>
                <c:pt idx="73">
                  <c:v>4.2471501095881701</c:v>
                </c:pt>
                <c:pt idx="74">
                  <c:v>4.0569737360084499</c:v>
                </c:pt>
                <c:pt idx="75">
                  <c:v>3.7327990529251802</c:v>
                </c:pt>
                <c:pt idx="76">
                  <c:v>3.6346477777795201</c:v>
                </c:pt>
                <c:pt idx="77">
                  <c:v>3.49047166547627</c:v>
                </c:pt>
                <c:pt idx="78">
                  <c:v>3.39541699346309</c:v>
                </c:pt>
                <c:pt idx="79">
                  <c:v>3.3874483030241</c:v>
                </c:pt>
                <c:pt idx="80">
                  <c:v>3.26864023225481</c:v>
                </c:pt>
                <c:pt idx="81">
                  <c:v>3.2324926572267101</c:v>
                </c:pt>
                <c:pt idx="82">
                  <c:v>3.20664128687456</c:v>
                </c:pt>
                <c:pt idx="83">
                  <c:v>3.2030662632993399</c:v>
                </c:pt>
                <c:pt idx="84">
                  <c:v>3.1181123428234101</c:v>
                </c:pt>
                <c:pt idx="85">
                  <c:v>3.0761353873162798</c:v>
                </c:pt>
                <c:pt idx="86">
                  <c:v>3.0450953293890399</c:v>
                </c:pt>
                <c:pt idx="87">
                  <c:v>2.91623223933381</c:v>
                </c:pt>
                <c:pt idx="88">
                  <c:v>2.8814590073722202</c:v>
                </c:pt>
                <c:pt idx="89">
                  <c:v>2.6458367944597301</c:v>
                </c:pt>
                <c:pt idx="90">
                  <c:v>2.6131253416572999</c:v>
                </c:pt>
                <c:pt idx="91">
                  <c:v>2.4340116392190998</c:v>
                </c:pt>
                <c:pt idx="92">
                  <c:v>2.3305047917056201</c:v>
                </c:pt>
                <c:pt idx="93">
                  <c:v>2.31869933292153</c:v>
                </c:pt>
                <c:pt idx="94">
                  <c:v>2.2767648889840002</c:v>
                </c:pt>
                <c:pt idx="95">
                  <c:v>2.2360046056269001</c:v>
                </c:pt>
                <c:pt idx="96">
                  <c:v>2.1849309774268999</c:v>
                </c:pt>
                <c:pt idx="97">
                  <c:v>2.1150719105692599</c:v>
                </c:pt>
                <c:pt idx="98">
                  <c:v>2.08915112566274</c:v>
                </c:pt>
                <c:pt idx="99">
                  <c:v>2.06973658306286</c:v>
                </c:pt>
                <c:pt idx="100">
                  <c:v>2.0303296998539202</c:v>
                </c:pt>
                <c:pt idx="101">
                  <c:v>1.6992552049530101</c:v>
                </c:pt>
                <c:pt idx="102">
                  <c:v>1.6403894382312101</c:v>
                </c:pt>
                <c:pt idx="103">
                  <c:v>1.6374953041400699</c:v>
                </c:pt>
                <c:pt idx="104">
                  <c:v>1.5805873226703999</c:v>
                </c:pt>
                <c:pt idx="105">
                  <c:v>1.44293933336701</c:v>
                </c:pt>
                <c:pt idx="106">
                  <c:v>1.29858756303654</c:v>
                </c:pt>
              </c:numCache>
            </c:numRef>
          </c:xVal>
          <c:yVal>
            <c:numRef>
              <c:f>Sheet1!$T$7:$T$113</c:f>
              <c:numCache>
                <c:formatCode>General</c:formatCode>
                <c:ptCount val="107"/>
                <c:pt idx="0">
                  <c:v>2.9099999999999999E-35</c:v>
                </c:pt>
                <c:pt idx="1">
                  <c:v>1.43E-24</c:v>
                </c:pt>
                <c:pt idx="2">
                  <c:v>6.9699999999999996E-38</c:v>
                </c:pt>
                <c:pt idx="3">
                  <c:v>2.7699999999999999E-43</c:v>
                </c:pt>
                <c:pt idx="4">
                  <c:v>1.04E-16</c:v>
                </c:pt>
                <c:pt idx="5">
                  <c:v>6.2599999999999998E-33</c:v>
                </c:pt>
                <c:pt idx="6">
                  <c:v>4.3600000000000003E-43</c:v>
                </c:pt>
                <c:pt idx="7">
                  <c:v>2.2400000000000001E-44</c:v>
                </c:pt>
                <c:pt idx="8">
                  <c:v>4.7099999999999999E-26</c:v>
                </c:pt>
                <c:pt idx="9">
                  <c:v>3.2200000000000001E-27</c:v>
                </c:pt>
                <c:pt idx="10">
                  <c:v>2.2400000000000002E-19</c:v>
                </c:pt>
                <c:pt idx="11">
                  <c:v>9.3499999999999996E-24</c:v>
                </c:pt>
                <c:pt idx="12">
                  <c:v>4.1399999999999996E-34</c:v>
                </c:pt>
                <c:pt idx="13">
                  <c:v>8.72E-42</c:v>
                </c:pt>
                <c:pt idx="14">
                  <c:v>8.1800000000000005E-8</c:v>
                </c:pt>
                <c:pt idx="15">
                  <c:v>1.16E-32</c:v>
                </c:pt>
                <c:pt idx="16">
                  <c:v>1.5E-28</c:v>
                </c:pt>
                <c:pt idx="17">
                  <c:v>5.0899999999999999E-20</c:v>
                </c:pt>
                <c:pt idx="18">
                  <c:v>1.08E-35</c:v>
                </c:pt>
                <c:pt idx="19">
                  <c:v>5.2200000000000001E-27</c:v>
                </c:pt>
                <c:pt idx="20">
                  <c:v>8.0499999999999994E-36</c:v>
                </c:pt>
                <c:pt idx="21">
                  <c:v>5.1999999999999999E-31</c:v>
                </c:pt>
                <c:pt idx="22">
                  <c:v>4.5900000000000001E-21</c:v>
                </c:pt>
                <c:pt idx="23">
                  <c:v>6.3399999999999997E-27</c:v>
                </c:pt>
                <c:pt idx="24">
                  <c:v>3.6700000000000003E-20</c:v>
                </c:pt>
                <c:pt idx="25">
                  <c:v>4.5799999999999998E-34</c:v>
                </c:pt>
                <c:pt idx="26">
                  <c:v>8.4499999999999998E-28</c:v>
                </c:pt>
                <c:pt idx="27">
                  <c:v>1.2699999999999999E-15</c:v>
                </c:pt>
                <c:pt idx="28">
                  <c:v>8.1100000000000003E-31</c:v>
                </c:pt>
                <c:pt idx="29">
                  <c:v>1.5399999999999999E-14</c:v>
                </c:pt>
                <c:pt idx="30">
                  <c:v>1.01E-20</c:v>
                </c:pt>
                <c:pt idx="31">
                  <c:v>3.1800000000000001E-14</c:v>
                </c:pt>
                <c:pt idx="32">
                  <c:v>3.1602817904926101E-25</c:v>
                </c:pt>
                <c:pt idx="33">
                  <c:v>1.6399999999999999E-24</c:v>
                </c:pt>
                <c:pt idx="34">
                  <c:v>7.0899999999999994E-26</c:v>
                </c:pt>
                <c:pt idx="35">
                  <c:v>1.8E-25</c:v>
                </c:pt>
                <c:pt idx="36">
                  <c:v>3.3599999999999998E-19</c:v>
                </c:pt>
                <c:pt idx="37">
                  <c:v>3.8899999999999999E-23</c:v>
                </c:pt>
                <c:pt idx="38">
                  <c:v>3.5000000000000002E-17</c:v>
                </c:pt>
                <c:pt idx="39">
                  <c:v>3.77E-20</c:v>
                </c:pt>
                <c:pt idx="40">
                  <c:v>7.04E-16</c:v>
                </c:pt>
                <c:pt idx="41">
                  <c:v>3.7899999999999997E-15</c:v>
                </c:pt>
                <c:pt idx="42">
                  <c:v>4.15E-13</c:v>
                </c:pt>
                <c:pt idx="43">
                  <c:v>1.23E-18</c:v>
                </c:pt>
                <c:pt idx="44">
                  <c:v>5.2300000000000003E-19</c:v>
                </c:pt>
                <c:pt idx="45">
                  <c:v>2.79E-14</c:v>
                </c:pt>
                <c:pt idx="46">
                  <c:v>1.6899999999999999E-21</c:v>
                </c:pt>
                <c:pt idx="47">
                  <c:v>6.5500000000000006E-11</c:v>
                </c:pt>
                <c:pt idx="48">
                  <c:v>1.02E-10</c:v>
                </c:pt>
                <c:pt idx="49">
                  <c:v>3.92E-14</c:v>
                </c:pt>
                <c:pt idx="50">
                  <c:v>1.9199999999999999E-16</c:v>
                </c:pt>
                <c:pt idx="51">
                  <c:v>1.5400000000000001E-17</c:v>
                </c:pt>
                <c:pt idx="52">
                  <c:v>5.16E-16</c:v>
                </c:pt>
                <c:pt idx="53">
                  <c:v>2.0500000000000001E-14</c:v>
                </c:pt>
                <c:pt idx="54">
                  <c:v>1.64E-15</c:v>
                </c:pt>
                <c:pt idx="55">
                  <c:v>2.9200000000000002E-19</c:v>
                </c:pt>
                <c:pt idx="56">
                  <c:v>3.76E-16</c:v>
                </c:pt>
                <c:pt idx="57">
                  <c:v>2.33E-12</c:v>
                </c:pt>
                <c:pt idx="58">
                  <c:v>6.7700000000000004E-14</c:v>
                </c:pt>
                <c:pt idx="59">
                  <c:v>3.7299999999999997E-17</c:v>
                </c:pt>
                <c:pt idx="60">
                  <c:v>4.5399999999999998E-10</c:v>
                </c:pt>
                <c:pt idx="61">
                  <c:v>7.0300000000000001E-14</c:v>
                </c:pt>
                <c:pt idx="62">
                  <c:v>7.1999999999999996E-14</c:v>
                </c:pt>
                <c:pt idx="63">
                  <c:v>1.9300000000000001E-13</c:v>
                </c:pt>
                <c:pt idx="64">
                  <c:v>1.04E-6</c:v>
                </c:pt>
                <c:pt idx="65">
                  <c:v>3.43E-10</c:v>
                </c:pt>
                <c:pt idx="66">
                  <c:v>2.6200000000000001E-12</c:v>
                </c:pt>
                <c:pt idx="67">
                  <c:v>3.8999999999999999E-12</c:v>
                </c:pt>
                <c:pt idx="68">
                  <c:v>2.72E-15</c:v>
                </c:pt>
                <c:pt idx="69">
                  <c:v>1.09E-12</c:v>
                </c:pt>
                <c:pt idx="70">
                  <c:v>3.12E-11</c:v>
                </c:pt>
                <c:pt idx="71">
                  <c:v>7.0299999999999995E-10</c:v>
                </c:pt>
                <c:pt idx="72">
                  <c:v>1.88E-10</c:v>
                </c:pt>
                <c:pt idx="73">
                  <c:v>2.8700000000000001E-6</c:v>
                </c:pt>
                <c:pt idx="74">
                  <c:v>5.5099999999999998E-6</c:v>
                </c:pt>
                <c:pt idx="75">
                  <c:v>8.05E-8</c:v>
                </c:pt>
                <c:pt idx="76">
                  <c:v>6.4000000000000002E-9</c:v>
                </c:pt>
                <c:pt idx="77">
                  <c:v>1.72E-6</c:v>
                </c:pt>
                <c:pt idx="78">
                  <c:v>5.0799999999999999E-4</c:v>
                </c:pt>
                <c:pt idx="79">
                  <c:v>1.83E-4</c:v>
                </c:pt>
                <c:pt idx="80">
                  <c:v>4.0899999999999997E-9</c:v>
                </c:pt>
                <c:pt idx="81">
                  <c:v>9.9300000000000002E-9</c:v>
                </c:pt>
                <c:pt idx="82">
                  <c:v>7.1500000000000002E-6</c:v>
                </c:pt>
                <c:pt idx="83">
                  <c:v>1.42E-7</c:v>
                </c:pt>
                <c:pt idx="84">
                  <c:v>1.04E-5</c:v>
                </c:pt>
                <c:pt idx="85">
                  <c:v>1.0200000000000001E-5</c:v>
                </c:pt>
                <c:pt idx="86">
                  <c:v>1.2799999999999999E-5</c:v>
                </c:pt>
                <c:pt idx="87">
                  <c:v>9.8700000000000003E-3</c:v>
                </c:pt>
                <c:pt idx="88">
                  <c:v>4.8099999999999997E-6</c:v>
                </c:pt>
                <c:pt idx="89">
                  <c:v>3.5199999999999999E-4</c:v>
                </c:pt>
                <c:pt idx="90">
                  <c:v>5.4299999999999997E-4</c:v>
                </c:pt>
                <c:pt idx="91">
                  <c:v>4.4900000000000002E-4</c:v>
                </c:pt>
                <c:pt idx="92">
                  <c:v>4.2200000000000003E-5</c:v>
                </c:pt>
                <c:pt idx="93">
                  <c:v>2.2499999999999999E-4</c:v>
                </c:pt>
                <c:pt idx="94">
                  <c:v>4.9600000000000002E-4</c:v>
                </c:pt>
                <c:pt idx="95">
                  <c:v>2.7E-4</c:v>
                </c:pt>
                <c:pt idx="96">
                  <c:v>1.5200000000000001E-3</c:v>
                </c:pt>
                <c:pt idx="97">
                  <c:v>4.0899999999999999E-3</c:v>
                </c:pt>
                <c:pt idx="98">
                  <c:v>4.1900000000000001E-3</c:v>
                </c:pt>
                <c:pt idx="99">
                  <c:v>1.5100000000000001E-2</c:v>
                </c:pt>
                <c:pt idx="100">
                  <c:v>4.3E-3</c:v>
                </c:pt>
                <c:pt idx="101">
                  <c:v>5.11E-3</c:v>
                </c:pt>
                <c:pt idx="102">
                  <c:v>1.09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870040"/>
        <c:axId val="181093664"/>
      </c:scatterChart>
      <c:valAx>
        <c:axId val="181870040"/>
        <c:scaling>
          <c:orientation val="minMax"/>
        </c:scaling>
        <c:delete val="0"/>
        <c:axPos val="t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093664"/>
        <c:crosses val="autoZero"/>
        <c:crossBetween val="midCat"/>
        <c:majorUnit val="2"/>
      </c:valAx>
      <c:valAx>
        <c:axId val="181093664"/>
        <c:scaling>
          <c:logBase val="10"/>
          <c:orientation val="maxMin"/>
          <c:min val="1.0000000000000039E-67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87004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05126331705785"/>
          <c:y val="4.8627162271304279E-2"/>
          <c:w val="0.7668886848395382"/>
          <c:h val="0.86033751509380629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X$2</c:f>
              <c:strCache>
                <c:ptCount val="1"/>
                <c:pt idx="0">
                  <c:v>pvalu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7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0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1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2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2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2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xVal>
            <c:numRef>
              <c:f>Sheet1!$W$3:$W$130</c:f>
              <c:numCache>
                <c:formatCode>General</c:formatCode>
                <c:ptCount val="128"/>
                <c:pt idx="0">
                  <c:v>20.056474138292</c:v>
                </c:pt>
                <c:pt idx="1">
                  <c:v>18.748679713881799</c:v>
                </c:pt>
                <c:pt idx="2">
                  <c:v>18.201905267447302</c:v>
                </c:pt>
                <c:pt idx="3">
                  <c:v>16.9914196528125</c:v>
                </c:pt>
                <c:pt idx="4">
                  <c:v>16.838706310974199</c:v>
                </c:pt>
                <c:pt idx="5">
                  <c:v>16.0563131092029</c:v>
                </c:pt>
                <c:pt idx="6">
                  <c:v>15.810652612089999</c:v>
                </c:pt>
                <c:pt idx="7">
                  <c:v>15.2964926336278</c:v>
                </c:pt>
                <c:pt idx="8">
                  <c:v>14.462352045618699</c:v>
                </c:pt>
                <c:pt idx="9">
                  <c:v>13.8745418954041</c:v>
                </c:pt>
                <c:pt idx="10">
                  <c:v>13.568978642887799</c:v>
                </c:pt>
                <c:pt idx="11">
                  <c:v>13.0796016856963</c:v>
                </c:pt>
                <c:pt idx="12">
                  <c:v>12.6584230444311</c:v>
                </c:pt>
                <c:pt idx="13">
                  <c:v>12.6332035011103</c:v>
                </c:pt>
                <c:pt idx="14">
                  <c:v>12.074277035864499</c:v>
                </c:pt>
                <c:pt idx="15">
                  <c:v>11.965954730380099</c:v>
                </c:pt>
                <c:pt idx="16">
                  <c:v>11.921053560462401</c:v>
                </c:pt>
                <c:pt idx="17">
                  <c:v>11.755260568671099</c:v>
                </c:pt>
                <c:pt idx="18">
                  <c:v>11.691317980189901</c:v>
                </c:pt>
                <c:pt idx="19">
                  <c:v>11.472282043596699</c:v>
                </c:pt>
                <c:pt idx="20">
                  <c:v>11.4623887008925</c:v>
                </c:pt>
                <c:pt idx="21">
                  <c:v>10.9241492958778</c:v>
                </c:pt>
                <c:pt idx="22">
                  <c:v>10.3794802367619</c:v>
                </c:pt>
                <c:pt idx="23">
                  <c:v>10.238110439891299</c:v>
                </c:pt>
                <c:pt idx="24">
                  <c:v>10.177851323321301</c:v>
                </c:pt>
                <c:pt idx="25">
                  <c:v>10.016874671570999</c:v>
                </c:pt>
                <c:pt idx="26">
                  <c:v>9.6656830110748793</c:v>
                </c:pt>
                <c:pt idx="27">
                  <c:v>9.2769741561638792</c:v>
                </c:pt>
                <c:pt idx="28">
                  <c:v>9.1959531358220499</c:v>
                </c:pt>
                <c:pt idx="29">
                  <c:v>8.9797752305733098</c:v>
                </c:pt>
                <c:pt idx="30">
                  <c:v>8.8505433135500393</c:v>
                </c:pt>
                <c:pt idx="31">
                  <c:v>8.68879704120166</c:v>
                </c:pt>
                <c:pt idx="32">
                  <c:v>8.6487534128396</c:v>
                </c:pt>
                <c:pt idx="33">
                  <c:v>8.5343425020099399</c:v>
                </c:pt>
                <c:pt idx="34">
                  <c:v>8.4517901095193295</c:v>
                </c:pt>
                <c:pt idx="35">
                  <c:v>8.39910931285117</c:v>
                </c:pt>
                <c:pt idx="36">
                  <c:v>8.3099247706705501</c:v>
                </c:pt>
                <c:pt idx="37">
                  <c:v>8.2671506133150903</c:v>
                </c:pt>
                <c:pt idx="38">
                  <c:v>8.1226253355518097</c:v>
                </c:pt>
                <c:pt idx="39">
                  <c:v>8.0650068913517696</c:v>
                </c:pt>
                <c:pt idx="40">
                  <c:v>8.0429529058518696</c:v>
                </c:pt>
                <c:pt idx="41">
                  <c:v>7.9181825148766398</c:v>
                </c:pt>
                <c:pt idx="42">
                  <c:v>7.7627552611126101</c:v>
                </c:pt>
                <c:pt idx="43">
                  <c:v>7.5009490728319301</c:v>
                </c:pt>
                <c:pt idx="44">
                  <c:v>7.32694153728501</c:v>
                </c:pt>
                <c:pt idx="45">
                  <c:v>7.3083771230877996</c:v>
                </c:pt>
                <c:pt idx="46">
                  <c:v>7.0294592634641599</c:v>
                </c:pt>
                <c:pt idx="47">
                  <c:v>6.9846687355228099</c:v>
                </c:pt>
                <c:pt idx="48">
                  <c:v>6.8564568304228697</c:v>
                </c:pt>
                <c:pt idx="49">
                  <c:v>6.3586840722836504</c:v>
                </c:pt>
                <c:pt idx="50">
                  <c:v>6.2130729376770804</c:v>
                </c:pt>
                <c:pt idx="51">
                  <c:v>5.9972234673182099</c:v>
                </c:pt>
                <c:pt idx="52">
                  <c:v>5.9648017526233099</c:v>
                </c:pt>
                <c:pt idx="53">
                  <c:v>5.9603791449570398</c:v>
                </c:pt>
                <c:pt idx="54">
                  <c:v>5.8772382968173504</c:v>
                </c:pt>
                <c:pt idx="55">
                  <c:v>5.8559909195461097</c:v>
                </c:pt>
                <c:pt idx="56">
                  <c:v>5.7863862899108298</c:v>
                </c:pt>
                <c:pt idx="57">
                  <c:v>5.5930124517319904</c:v>
                </c:pt>
                <c:pt idx="58">
                  <c:v>5.5264201540475497</c:v>
                </c:pt>
                <c:pt idx="59">
                  <c:v>5.5223475333292598</c:v>
                </c:pt>
                <c:pt idx="60">
                  <c:v>5.5099217830199096</c:v>
                </c:pt>
                <c:pt idx="61">
                  <c:v>5.4044990288627002</c:v>
                </c:pt>
                <c:pt idx="62">
                  <c:v>5.1538011940454602</c:v>
                </c:pt>
                <c:pt idx="63">
                  <c:v>5.1522659735082597</c:v>
                </c:pt>
                <c:pt idx="64">
                  <c:v>5.1120654240949301</c:v>
                </c:pt>
                <c:pt idx="65">
                  <c:v>5.0752085742715796</c:v>
                </c:pt>
                <c:pt idx="66">
                  <c:v>4.8561077368436898</c:v>
                </c:pt>
                <c:pt idx="67">
                  <c:v>4.7472499091201596</c:v>
                </c:pt>
                <c:pt idx="68">
                  <c:v>4.6363966825433298</c:v>
                </c:pt>
                <c:pt idx="69">
                  <c:v>4.4949237992165001</c:v>
                </c:pt>
                <c:pt idx="70">
                  <c:v>4.4618626388380997</c:v>
                </c:pt>
                <c:pt idx="71">
                  <c:v>4.4594424438272799</c:v>
                </c:pt>
                <c:pt idx="72">
                  <c:v>4.3173539219435</c:v>
                </c:pt>
                <c:pt idx="73">
                  <c:v>4.2157581090729304</c:v>
                </c:pt>
                <c:pt idx="74">
                  <c:v>4.1613318607936902</c:v>
                </c:pt>
                <c:pt idx="75">
                  <c:v>4.1429949111447497</c:v>
                </c:pt>
                <c:pt idx="76">
                  <c:v>4.0565387956671497</c:v>
                </c:pt>
                <c:pt idx="77">
                  <c:v>4.0465300837951501</c:v>
                </c:pt>
                <c:pt idx="78">
                  <c:v>4.0408181941941699</c:v>
                </c:pt>
                <c:pt idx="79">
                  <c:v>3.9627205146694799</c:v>
                </c:pt>
                <c:pt idx="80">
                  <c:v>3.7980585989418101</c:v>
                </c:pt>
                <c:pt idx="81">
                  <c:v>3.7084917595414799</c:v>
                </c:pt>
                <c:pt idx="82">
                  <c:v>3.6626725623371801</c:v>
                </c:pt>
                <c:pt idx="83">
                  <c:v>3.51641194457217</c:v>
                </c:pt>
                <c:pt idx="84">
                  <c:v>3.47706175050405</c:v>
                </c:pt>
                <c:pt idx="85">
                  <c:v>3.4346915059378098</c:v>
                </c:pt>
                <c:pt idx="86">
                  <c:v>3.2610467179613098</c:v>
                </c:pt>
                <c:pt idx="87">
                  <c:v>3.2340491548843602</c:v>
                </c:pt>
                <c:pt idx="88">
                  <c:v>3.2200140960861501</c:v>
                </c:pt>
                <c:pt idx="89">
                  <c:v>3.1464512256315902</c:v>
                </c:pt>
                <c:pt idx="90">
                  <c:v>3.1170070650464399</c:v>
                </c:pt>
                <c:pt idx="91">
                  <c:v>3.0822134160736199</c:v>
                </c:pt>
                <c:pt idx="92">
                  <c:v>3.0440750582156202</c:v>
                </c:pt>
                <c:pt idx="93">
                  <c:v>2.96888927795885</c:v>
                </c:pt>
                <c:pt idx="94">
                  <c:v>2.9358138750321898</c:v>
                </c:pt>
                <c:pt idx="95">
                  <c:v>2.7823131365407399</c:v>
                </c:pt>
                <c:pt idx="96">
                  <c:v>2.70593507060113</c:v>
                </c:pt>
                <c:pt idx="97">
                  <c:v>2.7022354038515402</c:v>
                </c:pt>
                <c:pt idx="98">
                  <c:v>2.6981949948812001</c:v>
                </c:pt>
                <c:pt idx="99">
                  <c:v>2.48489760537089</c:v>
                </c:pt>
                <c:pt idx="100">
                  <c:v>2.4687639966762802</c:v>
                </c:pt>
                <c:pt idx="101">
                  <c:v>2.44865233946609</c:v>
                </c:pt>
                <c:pt idx="102">
                  <c:v>2.4127463142150201</c:v>
                </c:pt>
                <c:pt idx="103">
                  <c:v>2.3408409032640498</c:v>
                </c:pt>
                <c:pt idx="104">
                  <c:v>2.28743235588512</c:v>
                </c:pt>
                <c:pt idx="105">
                  <c:v>2.2311992206932501</c:v>
                </c:pt>
                <c:pt idx="106">
                  <c:v>2.17522217045099</c:v>
                </c:pt>
                <c:pt idx="107">
                  <c:v>2.1601168042439198</c:v>
                </c:pt>
                <c:pt idx="108">
                  <c:v>2.1263510456724002</c:v>
                </c:pt>
                <c:pt idx="109">
                  <c:v>2.0849208655543601</c:v>
                </c:pt>
                <c:pt idx="110">
                  <c:v>2.0628591038945698</c:v>
                </c:pt>
                <c:pt idx="111">
                  <c:v>2.0465289094810299</c:v>
                </c:pt>
                <c:pt idx="112">
                  <c:v>1.9877947362430499</c:v>
                </c:pt>
                <c:pt idx="113">
                  <c:v>1.9790739742168999</c:v>
                </c:pt>
                <c:pt idx="114">
                  <c:v>1.93097469104344</c:v>
                </c:pt>
                <c:pt idx="115">
                  <c:v>1.91506313848295</c:v>
                </c:pt>
                <c:pt idx="116">
                  <c:v>1.83569084945516</c:v>
                </c:pt>
                <c:pt idx="117">
                  <c:v>1.8318144181307301</c:v>
                </c:pt>
                <c:pt idx="118">
                  <c:v>1.8052830094805401</c:v>
                </c:pt>
                <c:pt idx="119">
                  <c:v>1.79474916920108</c:v>
                </c:pt>
                <c:pt idx="120">
                  <c:v>1.7191540332034201</c:v>
                </c:pt>
                <c:pt idx="121">
                  <c:v>1.6870532291392999</c:v>
                </c:pt>
                <c:pt idx="122">
                  <c:v>1.6367555116777299</c:v>
                </c:pt>
                <c:pt idx="123">
                  <c:v>1.5982115931388401</c:v>
                </c:pt>
                <c:pt idx="124">
                  <c:v>1.58993331310167</c:v>
                </c:pt>
                <c:pt idx="125">
                  <c:v>1.50169615535797</c:v>
                </c:pt>
                <c:pt idx="126">
                  <c:v>1.4824073734016201</c:v>
                </c:pt>
                <c:pt idx="127">
                  <c:v>1.47863223279819</c:v>
                </c:pt>
              </c:numCache>
            </c:numRef>
          </c:xVal>
          <c:yVal>
            <c:numRef>
              <c:f>Sheet1!$X$3:$X$130</c:f>
              <c:numCache>
                <c:formatCode>General</c:formatCode>
                <c:ptCount val="128"/>
                <c:pt idx="0">
                  <c:v>2.7699999999999999E-27</c:v>
                </c:pt>
                <c:pt idx="1">
                  <c:v>7.3700000000000003E-50</c:v>
                </c:pt>
                <c:pt idx="2">
                  <c:v>1.5500000000000001E-40</c:v>
                </c:pt>
                <c:pt idx="3">
                  <c:v>7.9500000000000005E-52</c:v>
                </c:pt>
                <c:pt idx="4">
                  <c:v>1.39E-36</c:v>
                </c:pt>
                <c:pt idx="5">
                  <c:v>5.9700000000000003E-68</c:v>
                </c:pt>
                <c:pt idx="6">
                  <c:v>5.12E-50</c:v>
                </c:pt>
                <c:pt idx="7">
                  <c:v>5.3299999999999996E-53</c:v>
                </c:pt>
                <c:pt idx="8">
                  <c:v>4.8100000000000001E-49</c:v>
                </c:pt>
                <c:pt idx="9">
                  <c:v>2.1899999999999999E-42</c:v>
                </c:pt>
                <c:pt idx="10">
                  <c:v>2.86E-41</c:v>
                </c:pt>
                <c:pt idx="11">
                  <c:v>2.4599999999999999E-36</c:v>
                </c:pt>
                <c:pt idx="12">
                  <c:v>1.11E-37</c:v>
                </c:pt>
                <c:pt idx="13">
                  <c:v>9.1500000000000004E-48</c:v>
                </c:pt>
                <c:pt idx="14">
                  <c:v>5.1200000000000004E-28</c:v>
                </c:pt>
                <c:pt idx="15">
                  <c:v>4.1700000000000003E-46</c:v>
                </c:pt>
                <c:pt idx="16">
                  <c:v>3.7099999999999999E-40</c:v>
                </c:pt>
                <c:pt idx="17">
                  <c:v>5.4200000000000001E-33</c:v>
                </c:pt>
                <c:pt idx="18">
                  <c:v>9.4399999999999996E-42</c:v>
                </c:pt>
                <c:pt idx="19">
                  <c:v>4.27E-28</c:v>
                </c:pt>
                <c:pt idx="20">
                  <c:v>9.3100000000000002E-38</c:v>
                </c:pt>
                <c:pt idx="21">
                  <c:v>1.8100000000000001E-28</c:v>
                </c:pt>
                <c:pt idx="22">
                  <c:v>6.5500000000000002E-24</c:v>
                </c:pt>
                <c:pt idx="23">
                  <c:v>4.2999999999999999E-32</c:v>
                </c:pt>
                <c:pt idx="24">
                  <c:v>9.9499999999999994E-24</c:v>
                </c:pt>
                <c:pt idx="25">
                  <c:v>2.5021855391648201E-44</c:v>
                </c:pt>
                <c:pt idx="26">
                  <c:v>5.2299999999999996E-29</c:v>
                </c:pt>
                <c:pt idx="27">
                  <c:v>4.5399999999999996E-12</c:v>
                </c:pt>
                <c:pt idx="28">
                  <c:v>6.76E-24</c:v>
                </c:pt>
                <c:pt idx="29">
                  <c:v>2.56E-33</c:v>
                </c:pt>
                <c:pt idx="30">
                  <c:v>1.3000000000000001E-29</c:v>
                </c:pt>
                <c:pt idx="31">
                  <c:v>2.9700000000000002E-35</c:v>
                </c:pt>
                <c:pt idx="32">
                  <c:v>2.0300000000000001E-23</c:v>
                </c:pt>
                <c:pt idx="33">
                  <c:v>1.6099999999999999E-23</c:v>
                </c:pt>
                <c:pt idx="34">
                  <c:v>4.8900000000000001E-22</c:v>
                </c:pt>
                <c:pt idx="35">
                  <c:v>5.8199999999999996E-32</c:v>
                </c:pt>
                <c:pt idx="36">
                  <c:v>1.13E-25</c:v>
                </c:pt>
                <c:pt idx="37">
                  <c:v>6.38E-27</c:v>
                </c:pt>
                <c:pt idx="38">
                  <c:v>1.03E-26</c:v>
                </c:pt>
                <c:pt idx="39">
                  <c:v>1.0700000000000001E-7</c:v>
                </c:pt>
                <c:pt idx="40">
                  <c:v>9.4299999999999999E-29</c:v>
                </c:pt>
                <c:pt idx="41">
                  <c:v>1.37E-24</c:v>
                </c:pt>
                <c:pt idx="42">
                  <c:v>1.4100000000000001E-19</c:v>
                </c:pt>
                <c:pt idx="43">
                  <c:v>5.6199999999999996E-16</c:v>
                </c:pt>
                <c:pt idx="44">
                  <c:v>1.0299999999999999E-21</c:v>
                </c:pt>
                <c:pt idx="45">
                  <c:v>1.13E-22</c:v>
                </c:pt>
                <c:pt idx="46">
                  <c:v>2.24E-20</c:v>
                </c:pt>
                <c:pt idx="47">
                  <c:v>2.89E-22</c:v>
                </c:pt>
                <c:pt idx="48">
                  <c:v>1.9599999999999999E-11</c:v>
                </c:pt>
                <c:pt idx="49">
                  <c:v>4.9700000000000003E-19</c:v>
                </c:pt>
                <c:pt idx="50">
                  <c:v>1.74E-18</c:v>
                </c:pt>
                <c:pt idx="51">
                  <c:v>2.8799999999999998E-22</c:v>
                </c:pt>
                <c:pt idx="52">
                  <c:v>2.66E-17</c:v>
                </c:pt>
                <c:pt idx="53">
                  <c:v>1.2499999999999999E-22</c:v>
                </c:pt>
                <c:pt idx="54">
                  <c:v>2.5000000000000001E-14</c:v>
                </c:pt>
                <c:pt idx="55">
                  <c:v>1.6299999999999999E-7</c:v>
                </c:pt>
                <c:pt idx="56">
                  <c:v>8.6000000000000005E-18</c:v>
                </c:pt>
                <c:pt idx="57">
                  <c:v>9.0799999999999992E-15</c:v>
                </c:pt>
                <c:pt idx="58">
                  <c:v>6.7699999999999996E-16</c:v>
                </c:pt>
                <c:pt idx="59">
                  <c:v>5.3399999999999998E-11</c:v>
                </c:pt>
                <c:pt idx="60">
                  <c:v>1.0900000000000001E-19</c:v>
                </c:pt>
                <c:pt idx="61">
                  <c:v>1.65E-17</c:v>
                </c:pt>
                <c:pt idx="62">
                  <c:v>1.4700000000000001E-20</c:v>
                </c:pt>
                <c:pt idx="63">
                  <c:v>6.1800000000000001E-17</c:v>
                </c:pt>
                <c:pt idx="64">
                  <c:v>1.6900000000000001E-12</c:v>
                </c:pt>
                <c:pt idx="65">
                  <c:v>1.01E-15</c:v>
                </c:pt>
                <c:pt idx="66">
                  <c:v>1.71E-15</c:v>
                </c:pt>
                <c:pt idx="67">
                  <c:v>5.68E-13</c:v>
                </c:pt>
                <c:pt idx="68">
                  <c:v>6.3899999999999998E-14</c:v>
                </c:pt>
                <c:pt idx="69">
                  <c:v>1.93E-14</c:v>
                </c:pt>
                <c:pt idx="70">
                  <c:v>2.87E-14</c:v>
                </c:pt>
                <c:pt idx="71">
                  <c:v>2.61E-16</c:v>
                </c:pt>
                <c:pt idx="72">
                  <c:v>1.2199999999999999E-14</c:v>
                </c:pt>
                <c:pt idx="73">
                  <c:v>4.1599999999999999E-13</c:v>
                </c:pt>
                <c:pt idx="74">
                  <c:v>5.4499999999999998E-10</c:v>
                </c:pt>
                <c:pt idx="75">
                  <c:v>5.4200000000000001E-13</c:v>
                </c:pt>
                <c:pt idx="76">
                  <c:v>4.7900000000000003E-14</c:v>
                </c:pt>
                <c:pt idx="77">
                  <c:v>5.5499999999999997E-14</c:v>
                </c:pt>
                <c:pt idx="78">
                  <c:v>4.4400000000000004E-9</c:v>
                </c:pt>
                <c:pt idx="79">
                  <c:v>2.9900000000000003E-8</c:v>
                </c:pt>
                <c:pt idx="80">
                  <c:v>1.39E-9</c:v>
                </c:pt>
                <c:pt idx="81">
                  <c:v>5.49E-5</c:v>
                </c:pt>
                <c:pt idx="82">
                  <c:v>2.4E-9</c:v>
                </c:pt>
                <c:pt idx="83">
                  <c:v>2.1499999999999998E-9</c:v>
                </c:pt>
                <c:pt idx="84">
                  <c:v>9.2000000000000005E-11</c:v>
                </c:pt>
                <c:pt idx="85">
                  <c:v>2.37E-8</c:v>
                </c:pt>
                <c:pt idx="86">
                  <c:v>2.4800000000000002E-10</c:v>
                </c:pt>
                <c:pt idx="87">
                  <c:v>1.9000000000000001E-5</c:v>
                </c:pt>
                <c:pt idx="88">
                  <c:v>3.5200000000000002E-6</c:v>
                </c:pt>
                <c:pt idx="89">
                  <c:v>5.5899999999999999E-9</c:v>
                </c:pt>
                <c:pt idx="90">
                  <c:v>3.5400000000000002E-7</c:v>
                </c:pt>
                <c:pt idx="91">
                  <c:v>8.77E-3</c:v>
                </c:pt>
                <c:pt idx="92">
                  <c:v>2.4200000000000002E-8</c:v>
                </c:pt>
                <c:pt idx="93">
                  <c:v>7.4599999999999997E-6</c:v>
                </c:pt>
                <c:pt idx="94">
                  <c:v>2.4000000000000001E-5</c:v>
                </c:pt>
                <c:pt idx="95">
                  <c:v>1.3900000000000001E-5</c:v>
                </c:pt>
                <c:pt idx="96">
                  <c:v>1.5099999999999999E-5</c:v>
                </c:pt>
                <c:pt idx="97">
                  <c:v>5.7000000000000005E-7</c:v>
                </c:pt>
                <c:pt idx="98">
                  <c:v>5.0499999999999999E-6</c:v>
                </c:pt>
                <c:pt idx="99">
                  <c:v>4.6800000000000001E-7</c:v>
                </c:pt>
                <c:pt idx="100">
                  <c:v>5.2400000000000005E-4</c:v>
                </c:pt>
                <c:pt idx="101">
                  <c:v>1.33E-5</c:v>
                </c:pt>
                <c:pt idx="102">
                  <c:v>1.06E-5</c:v>
                </c:pt>
                <c:pt idx="103">
                  <c:v>3.9400000000000002E-5</c:v>
                </c:pt>
                <c:pt idx="104">
                  <c:v>4.5399999999999999E-5</c:v>
                </c:pt>
                <c:pt idx="105">
                  <c:v>1.9100000000000001E-4</c:v>
                </c:pt>
                <c:pt idx="106">
                  <c:v>1.3799999999999999E-4</c:v>
                </c:pt>
                <c:pt idx="107">
                  <c:v>1.55E-4</c:v>
                </c:pt>
                <c:pt idx="108">
                  <c:v>4.1399999999999997E-5</c:v>
                </c:pt>
                <c:pt idx="109">
                  <c:v>2.1699999999999999E-5</c:v>
                </c:pt>
                <c:pt idx="110">
                  <c:v>5.3700000000000004E-4</c:v>
                </c:pt>
                <c:pt idx="111">
                  <c:v>7.3300000000000006E-5</c:v>
                </c:pt>
                <c:pt idx="112">
                  <c:v>5.1800000000000001E-4</c:v>
                </c:pt>
                <c:pt idx="113">
                  <c:v>2.5399999999999999E-4</c:v>
                </c:pt>
                <c:pt idx="114">
                  <c:v>3.3199999999999999E-4</c:v>
                </c:pt>
                <c:pt idx="115">
                  <c:v>1.0300000000000001E-3</c:v>
                </c:pt>
                <c:pt idx="116">
                  <c:v>9.5799999999999998E-4</c:v>
                </c:pt>
                <c:pt idx="117">
                  <c:v>9.859999999999999E-4</c:v>
                </c:pt>
                <c:pt idx="118">
                  <c:v>1.04E-2</c:v>
                </c:pt>
                <c:pt idx="119">
                  <c:v>1.65E-3</c:v>
                </c:pt>
                <c:pt idx="120">
                  <c:v>3.31E-3</c:v>
                </c:pt>
                <c:pt idx="121">
                  <c:v>9.9299999999999996E-4</c:v>
                </c:pt>
                <c:pt idx="122">
                  <c:v>8.3699999999999996E-4</c:v>
                </c:pt>
                <c:pt idx="123">
                  <c:v>3.3600000000000001E-3</c:v>
                </c:pt>
                <c:pt idx="124">
                  <c:v>1.9400000000000001E-3</c:v>
                </c:pt>
                <c:pt idx="125">
                  <c:v>9.5899999999999996E-3</c:v>
                </c:pt>
                <c:pt idx="126">
                  <c:v>4.8700000000000002E-3</c:v>
                </c:pt>
                <c:pt idx="127">
                  <c:v>5.7000000000000002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125064"/>
        <c:axId val="181123424"/>
      </c:scatterChart>
      <c:valAx>
        <c:axId val="181125064"/>
        <c:scaling>
          <c:orientation val="minMax"/>
        </c:scaling>
        <c:delete val="0"/>
        <c:axPos val="t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123424"/>
        <c:crosses val="autoZero"/>
        <c:crossBetween val="midCat"/>
        <c:majorUnit val="2"/>
      </c:valAx>
      <c:valAx>
        <c:axId val="181123424"/>
        <c:scaling>
          <c:logBase val="10"/>
          <c:orientation val="maxMin"/>
          <c:min val="1.0000000000000177E-1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12506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80964218367101"/>
          <c:y val="4.4566478543170626E-2"/>
          <c:w val="0.75173671684469723"/>
          <c:h val="0.861445785054310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P$2</c:f>
              <c:strCache>
                <c:ptCount val="1"/>
                <c:pt idx="0">
                  <c:v>pvalu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4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1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5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64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1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1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1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2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3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4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4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4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6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6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7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8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8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8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8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19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1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1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2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2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3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4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4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4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61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6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7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29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0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1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23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2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35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46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4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5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59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88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392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07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dPt>
            <c:idx val="410"/>
            <c:marker>
              <c:symbol val="circle"/>
              <c:size val="5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</c:dPt>
          <c:xVal>
            <c:numRef>
              <c:f>Sheet1!$O$3:$O$448</c:f>
              <c:numCache>
                <c:formatCode>General</c:formatCode>
                <c:ptCount val="446"/>
                <c:pt idx="0">
                  <c:v>20.317364620212299</c:v>
                </c:pt>
                <c:pt idx="1">
                  <c:v>19.8229635691605</c:v>
                </c:pt>
                <c:pt idx="2">
                  <c:v>19.474929446285799</c:v>
                </c:pt>
                <c:pt idx="3">
                  <c:v>17.721658038723</c:v>
                </c:pt>
                <c:pt idx="4">
                  <c:v>17.3637685913083</c:v>
                </c:pt>
                <c:pt idx="5">
                  <c:v>16.724455156493701</c:v>
                </c:pt>
                <c:pt idx="6">
                  <c:v>16.658081685053599</c:v>
                </c:pt>
                <c:pt idx="7">
                  <c:v>16.377157754102299</c:v>
                </c:pt>
                <c:pt idx="8">
                  <c:v>15.9462182198275</c:v>
                </c:pt>
                <c:pt idx="9">
                  <c:v>15.918714800564301</c:v>
                </c:pt>
                <c:pt idx="10">
                  <c:v>15.3354732340424</c:v>
                </c:pt>
                <c:pt idx="11">
                  <c:v>15.1784442234555</c:v>
                </c:pt>
                <c:pt idx="12">
                  <c:v>14.5780496641799</c:v>
                </c:pt>
                <c:pt idx="13">
                  <c:v>14.326221911532601</c:v>
                </c:pt>
                <c:pt idx="14">
                  <c:v>14.2106984139267</c:v>
                </c:pt>
                <c:pt idx="15">
                  <c:v>14.03969241966</c:v>
                </c:pt>
                <c:pt idx="16">
                  <c:v>13.9389729649568</c:v>
                </c:pt>
                <c:pt idx="17">
                  <c:v>13.7832060971517</c:v>
                </c:pt>
                <c:pt idx="18">
                  <c:v>13.040568235620199</c:v>
                </c:pt>
                <c:pt idx="19">
                  <c:v>13.0264617451507</c:v>
                </c:pt>
                <c:pt idx="20">
                  <c:v>12.9595961728488</c:v>
                </c:pt>
                <c:pt idx="21">
                  <c:v>12.8496555354777</c:v>
                </c:pt>
                <c:pt idx="22">
                  <c:v>12.804884941492601</c:v>
                </c:pt>
                <c:pt idx="23">
                  <c:v>12.556256667768499</c:v>
                </c:pt>
                <c:pt idx="24">
                  <c:v>12.5341765672188</c:v>
                </c:pt>
                <c:pt idx="25">
                  <c:v>12.5217868731576</c:v>
                </c:pt>
                <c:pt idx="26">
                  <c:v>12.305831464218899</c:v>
                </c:pt>
                <c:pt idx="27">
                  <c:v>12.2277661318435</c:v>
                </c:pt>
                <c:pt idx="28">
                  <c:v>12.1391898355424</c:v>
                </c:pt>
                <c:pt idx="29">
                  <c:v>11.963981535787701</c:v>
                </c:pt>
                <c:pt idx="30">
                  <c:v>11.8266593550461</c:v>
                </c:pt>
                <c:pt idx="31">
                  <c:v>11.7888824981962</c:v>
                </c:pt>
                <c:pt idx="32">
                  <c:v>11.6632867469466</c:v>
                </c:pt>
                <c:pt idx="33">
                  <c:v>11.44410905626</c:v>
                </c:pt>
                <c:pt idx="34">
                  <c:v>11.288049948521699</c:v>
                </c:pt>
                <c:pt idx="35">
                  <c:v>11.256019821153499</c:v>
                </c:pt>
                <c:pt idx="36">
                  <c:v>11.2292087738994</c:v>
                </c:pt>
                <c:pt idx="37">
                  <c:v>11.088806928370101</c:v>
                </c:pt>
                <c:pt idx="38">
                  <c:v>11.083895976131201</c:v>
                </c:pt>
                <c:pt idx="39">
                  <c:v>11.074548752421601</c:v>
                </c:pt>
                <c:pt idx="40">
                  <c:v>11.057040552770999</c:v>
                </c:pt>
                <c:pt idx="41">
                  <c:v>10.69880053746</c:v>
                </c:pt>
                <c:pt idx="42">
                  <c:v>10.6144611170853</c:v>
                </c:pt>
                <c:pt idx="43">
                  <c:v>10.477812356098401</c:v>
                </c:pt>
                <c:pt idx="44">
                  <c:v>10.3595830406869</c:v>
                </c:pt>
                <c:pt idx="45">
                  <c:v>10.3158343050391</c:v>
                </c:pt>
                <c:pt idx="46">
                  <c:v>10.3128513177244</c:v>
                </c:pt>
                <c:pt idx="47">
                  <c:v>10.074903009184499</c:v>
                </c:pt>
                <c:pt idx="48">
                  <c:v>10.025048758976901</c:v>
                </c:pt>
                <c:pt idx="49">
                  <c:v>9.9930824070398803</c:v>
                </c:pt>
                <c:pt idx="50">
                  <c:v>9.9465638424601295</c:v>
                </c:pt>
                <c:pt idx="51">
                  <c:v>9.89678954320018</c:v>
                </c:pt>
                <c:pt idx="52">
                  <c:v>9.8536755751351599</c:v>
                </c:pt>
                <c:pt idx="53">
                  <c:v>9.8524580211115609</c:v>
                </c:pt>
                <c:pt idx="54">
                  <c:v>9.7867323291110893</c:v>
                </c:pt>
                <c:pt idx="55">
                  <c:v>9.7121588271812307</c:v>
                </c:pt>
                <c:pt idx="56">
                  <c:v>9.6538631277467495</c:v>
                </c:pt>
                <c:pt idx="57">
                  <c:v>9.46543710191734</c:v>
                </c:pt>
                <c:pt idx="58">
                  <c:v>9.2307198678388005</c:v>
                </c:pt>
                <c:pt idx="59">
                  <c:v>9.1575205135201792</c:v>
                </c:pt>
                <c:pt idx="60">
                  <c:v>9.10655532480353</c:v>
                </c:pt>
                <c:pt idx="61">
                  <c:v>9.1030932085852498</c:v>
                </c:pt>
                <c:pt idx="62">
                  <c:v>8.9502847053437495</c:v>
                </c:pt>
                <c:pt idx="63">
                  <c:v>8.9356773549007897</c:v>
                </c:pt>
                <c:pt idx="64">
                  <c:v>8.8882078288042994</c:v>
                </c:pt>
                <c:pt idx="65">
                  <c:v>8.8405911931332994</c:v>
                </c:pt>
                <c:pt idx="66">
                  <c:v>8.8394609384662708</c:v>
                </c:pt>
                <c:pt idx="67">
                  <c:v>8.8346264057865103</c:v>
                </c:pt>
                <c:pt idx="68">
                  <c:v>8.8154014536640499</c:v>
                </c:pt>
                <c:pt idx="69">
                  <c:v>8.5831925763651409</c:v>
                </c:pt>
                <c:pt idx="70">
                  <c:v>8.5098081976458797</c:v>
                </c:pt>
                <c:pt idx="71">
                  <c:v>8.4682723950504393</c:v>
                </c:pt>
                <c:pt idx="72">
                  <c:v>8.4116061997988592</c:v>
                </c:pt>
                <c:pt idx="73">
                  <c:v>8.3723691634919906</c:v>
                </c:pt>
                <c:pt idx="74">
                  <c:v>8.3658495137864595</c:v>
                </c:pt>
                <c:pt idx="75">
                  <c:v>8.36125812360266</c:v>
                </c:pt>
                <c:pt idx="76">
                  <c:v>8.2664970983258801</c:v>
                </c:pt>
                <c:pt idx="77">
                  <c:v>8.2461677842628802</c:v>
                </c:pt>
                <c:pt idx="78">
                  <c:v>8.2213913729131605</c:v>
                </c:pt>
                <c:pt idx="79">
                  <c:v>8.08156132549402</c:v>
                </c:pt>
                <c:pt idx="80">
                  <c:v>8.0679427363951994</c:v>
                </c:pt>
                <c:pt idx="81">
                  <c:v>8.0310580644336902</c:v>
                </c:pt>
                <c:pt idx="82">
                  <c:v>7.9363579452667503</c:v>
                </c:pt>
                <c:pt idx="83">
                  <c:v>7.9237208933227903</c:v>
                </c:pt>
                <c:pt idx="84">
                  <c:v>7.9132165878940004</c:v>
                </c:pt>
                <c:pt idx="85">
                  <c:v>7.8906154740288397</c:v>
                </c:pt>
                <c:pt idx="86">
                  <c:v>7.8843574317834397</c:v>
                </c:pt>
                <c:pt idx="87">
                  <c:v>7.8456164162787498</c:v>
                </c:pt>
                <c:pt idx="88">
                  <c:v>7.7289964814912802</c:v>
                </c:pt>
                <c:pt idx="89">
                  <c:v>7.72047066508149</c:v>
                </c:pt>
                <c:pt idx="90">
                  <c:v>7.6033475796673704</c:v>
                </c:pt>
                <c:pt idx="91">
                  <c:v>7.5024581872222598</c:v>
                </c:pt>
                <c:pt idx="92">
                  <c:v>7.4788500548803301</c:v>
                </c:pt>
                <c:pt idx="93">
                  <c:v>7.4187988257284099</c:v>
                </c:pt>
                <c:pt idx="94">
                  <c:v>7.41825765318307</c:v>
                </c:pt>
                <c:pt idx="95">
                  <c:v>7.4123889695797303</c:v>
                </c:pt>
                <c:pt idx="96">
                  <c:v>7.3854518179466098</c:v>
                </c:pt>
                <c:pt idx="97">
                  <c:v>7.2851194480639201</c:v>
                </c:pt>
                <c:pt idx="98">
                  <c:v>7.225237705524</c:v>
                </c:pt>
                <c:pt idx="99">
                  <c:v>7.2018568942357497</c:v>
                </c:pt>
                <c:pt idx="100">
                  <c:v>7.1540061334306699</c:v>
                </c:pt>
                <c:pt idx="101">
                  <c:v>7.0485948178999998</c:v>
                </c:pt>
                <c:pt idx="102">
                  <c:v>6.9498431982294102</c:v>
                </c:pt>
                <c:pt idx="103">
                  <c:v>6.9192244898739101</c:v>
                </c:pt>
                <c:pt idx="104">
                  <c:v>6.8458874761528801</c:v>
                </c:pt>
                <c:pt idx="105">
                  <c:v>6.8306702226916798</c:v>
                </c:pt>
                <c:pt idx="106">
                  <c:v>6.8257774681360699</c:v>
                </c:pt>
                <c:pt idx="107">
                  <c:v>6.6833540385596004</c:v>
                </c:pt>
                <c:pt idx="108">
                  <c:v>6.6611343308721498</c:v>
                </c:pt>
                <c:pt idx="109">
                  <c:v>6.6450750659880802</c:v>
                </c:pt>
                <c:pt idx="110">
                  <c:v>6.6246255516842396</c:v>
                </c:pt>
                <c:pt idx="111">
                  <c:v>6.5425102300113096</c:v>
                </c:pt>
                <c:pt idx="112">
                  <c:v>6.5243093928574796</c:v>
                </c:pt>
                <c:pt idx="113">
                  <c:v>6.51873198381492</c:v>
                </c:pt>
                <c:pt idx="114">
                  <c:v>6.5045474933299099</c:v>
                </c:pt>
                <c:pt idx="115">
                  <c:v>6.49128500342806</c:v>
                </c:pt>
                <c:pt idx="116">
                  <c:v>6.48804077450382</c:v>
                </c:pt>
                <c:pt idx="117">
                  <c:v>6.4717941542122697</c:v>
                </c:pt>
                <c:pt idx="118">
                  <c:v>6.4673831084780904</c:v>
                </c:pt>
                <c:pt idx="119">
                  <c:v>6.4187560652830999</c:v>
                </c:pt>
                <c:pt idx="120">
                  <c:v>6.3270025567151302</c:v>
                </c:pt>
                <c:pt idx="121">
                  <c:v>6.3090810776798296</c:v>
                </c:pt>
                <c:pt idx="122">
                  <c:v>6.2156798114999701</c:v>
                </c:pt>
                <c:pt idx="123">
                  <c:v>6.1577639640187902</c:v>
                </c:pt>
                <c:pt idx="124">
                  <c:v>6.1267303426740298</c:v>
                </c:pt>
                <c:pt idx="125">
                  <c:v>6.1096184824535396</c:v>
                </c:pt>
                <c:pt idx="126">
                  <c:v>6.01767150163381</c:v>
                </c:pt>
                <c:pt idx="127">
                  <c:v>6.0104293287394999</c:v>
                </c:pt>
                <c:pt idx="128">
                  <c:v>5.9730806521684396</c:v>
                </c:pt>
                <c:pt idx="129">
                  <c:v>5.9376155650616598</c:v>
                </c:pt>
                <c:pt idx="130">
                  <c:v>5.9293507425459699</c:v>
                </c:pt>
                <c:pt idx="131">
                  <c:v>5.8541012803355397</c:v>
                </c:pt>
                <c:pt idx="132">
                  <c:v>5.7638595590296102</c:v>
                </c:pt>
                <c:pt idx="133">
                  <c:v>5.7620287548652396</c:v>
                </c:pt>
                <c:pt idx="134">
                  <c:v>5.7168168228601903</c:v>
                </c:pt>
                <c:pt idx="135">
                  <c:v>5.6804424546589898</c:v>
                </c:pt>
                <c:pt idx="136">
                  <c:v>5.65582187526035</c:v>
                </c:pt>
                <c:pt idx="137">
                  <c:v>5.6547848095806303</c:v>
                </c:pt>
                <c:pt idx="138">
                  <c:v>5.6483236360526297</c:v>
                </c:pt>
                <c:pt idx="139">
                  <c:v>5.54216618465263</c:v>
                </c:pt>
                <c:pt idx="140">
                  <c:v>5.5276065660088101</c:v>
                </c:pt>
                <c:pt idx="141">
                  <c:v>5.4929182848675797</c:v>
                </c:pt>
                <c:pt idx="142">
                  <c:v>5.4883072134224502</c:v>
                </c:pt>
                <c:pt idx="143">
                  <c:v>5.47976190479182</c:v>
                </c:pt>
                <c:pt idx="144">
                  <c:v>5.4770850489007001</c:v>
                </c:pt>
                <c:pt idx="145">
                  <c:v>5.42907125644874</c:v>
                </c:pt>
                <c:pt idx="146">
                  <c:v>5.3914565373569499</c:v>
                </c:pt>
                <c:pt idx="147">
                  <c:v>5.3308358745334496</c:v>
                </c:pt>
                <c:pt idx="148">
                  <c:v>5.3214398885285403</c:v>
                </c:pt>
                <c:pt idx="149">
                  <c:v>5.2949926766969098</c:v>
                </c:pt>
                <c:pt idx="150">
                  <c:v>5.2588511496754604</c:v>
                </c:pt>
                <c:pt idx="151">
                  <c:v>5.2574665500898501</c:v>
                </c:pt>
                <c:pt idx="152">
                  <c:v>5.2015839287921599</c:v>
                </c:pt>
                <c:pt idx="153">
                  <c:v>5.1269822096848401</c:v>
                </c:pt>
                <c:pt idx="154">
                  <c:v>5.0899985676263597</c:v>
                </c:pt>
                <c:pt idx="155">
                  <c:v>5.0898420017587096</c:v>
                </c:pt>
                <c:pt idx="156">
                  <c:v>5.0749370656501904</c:v>
                </c:pt>
                <c:pt idx="157">
                  <c:v>5.0744843321581401</c:v>
                </c:pt>
                <c:pt idx="158">
                  <c:v>5.0642250363634904</c:v>
                </c:pt>
                <c:pt idx="159">
                  <c:v>5.0341524981950903</c:v>
                </c:pt>
                <c:pt idx="160">
                  <c:v>5.01439235263142</c:v>
                </c:pt>
                <c:pt idx="161">
                  <c:v>4.9539682339347504</c:v>
                </c:pt>
                <c:pt idx="162">
                  <c:v>4.9293570021943403</c:v>
                </c:pt>
                <c:pt idx="163">
                  <c:v>4.9108392391316196</c:v>
                </c:pt>
                <c:pt idx="164">
                  <c:v>4.8884161773242703</c:v>
                </c:pt>
                <c:pt idx="165">
                  <c:v>4.8434532373402597</c:v>
                </c:pt>
                <c:pt idx="166">
                  <c:v>4.7908117053045096</c:v>
                </c:pt>
                <c:pt idx="167">
                  <c:v>4.7502210886906102</c:v>
                </c:pt>
                <c:pt idx="168">
                  <c:v>4.7276122991586096</c:v>
                </c:pt>
                <c:pt idx="169">
                  <c:v>4.7058081326121002</c:v>
                </c:pt>
                <c:pt idx="170">
                  <c:v>4.6143928132892098</c:v>
                </c:pt>
                <c:pt idx="171">
                  <c:v>4.4789720442332399</c:v>
                </c:pt>
                <c:pt idx="172">
                  <c:v>4.4775615602271097</c:v>
                </c:pt>
                <c:pt idx="173">
                  <c:v>4.4581026822643199</c:v>
                </c:pt>
                <c:pt idx="174">
                  <c:v>4.4511808204217003</c:v>
                </c:pt>
                <c:pt idx="175">
                  <c:v>4.4226350948436801</c:v>
                </c:pt>
                <c:pt idx="176">
                  <c:v>4.4027669285176403</c:v>
                </c:pt>
                <c:pt idx="177">
                  <c:v>4.4018988097739502</c:v>
                </c:pt>
                <c:pt idx="178">
                  <c:v>4.3526165502955303</c:v>
                </c:pt>
                <c:pt idx="179">
                  <c:v>4.3381751238952901</c:v>
                </c:pt>
                <c:pt idx="180">
                  <c:v>4.3172035851668999</c:v>
                </c:pt>
                <c:pt idx="181">
                  <c:v>4.3009492923222403</c:v>
                </c:pt>
                <c:pt idx="182">
                  <c:v>4.2395493978583403</c:v>
                </c:pt>
                <c:pt idx="183">
                  <c:v>4.2022341071343199</c:v>
                </c:pt>
                <c:pt idx="184">
                  <c:v>4.1957701231479403</c:v>
                </c:pt>
                <c:pt idx="185">
                  <c:v>4.1779916009351101</c:v>
                </c:pt>
                <c:pt idx="186">
                  <c:v>4.1424368699109202</c:v>
                </c:pt>
                <c:pt idx="187">
                  <c:v>4.0791340392687996</c:v>
                </c:pt>
                <c:pt idx="188">
                  <c:v>4.0737839397673596</c:v>
                </c:pt>
                <c:pt idx="189">
                  <c:v>4.0554385676649396</c:v>
                </c:pt>
                <c:pt idx="190">
                  <c:v>4.0549280425277301</c:v>
                </c:pt>
                <c:pt idx="191">
                  <c:v>4.0216494984995697</c:v>
                </c:pt>
                <c:pt idx="192">
                  <c:v>4.0185416932178102</c:v>
                </c:pt>
                <c:pt idx="193">
                  <c:v>4.0109316830866302</c:v>
                </c:pt>
                <c:pt idx="194">
                  <c:v>4.0081416380407502</c:v>
                </c:pt>
                <c:pt idx="195">
                  <c:v>3.9894574381966601</c:v>
                </c:pt>
                <c:pt idx="196">
                  <c:v>3.948650755868</c:v>
                </c:pt>
                <c:pt idx="197">
                  <c:v>3.93294299663311</c:v>
                </c:pt>
                <c:pt idx="198">
                  <c:v>3.9162446111412899</c:v>
                </c:pt>
                <c:pt idx="199">
                  <c:v>3.9124467325647698</c:v>
                </c:pt>
                <c:pt idx="200">
                  <c:v>3.88398767350761</c:v>
                </c:pt>
                <c:pt idx="201">
                  <c:v>3.8622087890582</c:v>
                </c:pt>
                <c:pt idx="202">
                  <c:v>3.83106428134862</c:v>
                </c:pt>
                <c:pt idx="203">
                  <c:v>3.82917278786327</c:v>
                </c:pt>
                <c:pt idx="204">
                  <c:v>3.80552222680579</c:v>
                </c:pt>
                <c:pt idx="205">
                  <c:v>3.8035048284475299</c:v>
                </c:pt>
                <c:pt idx="206">
                  <c:v>3.7413140117017498</c:v>
                </c:pt>
                <c:pt idx="207">
                  <c:v>3.7256998650062498</c:v>
                </c:pt>
                <c:pt idx="208">
                  <c:v>3.7069235961817601</c:v>
                </c:pt>
                <c:pt idx="209">
                  <c:v>3.6061353807952798</c:v>
                </c:pt>
                <c:pt idx="210">
                  <c:v>3.5972017936325398</c:v>
                </c:pt>
                <c:pt idx="211">
                  <c:v>3.5959236473268001</c:v>
                </c:pt>
                <c:pt idx="212">
                  <c:v>3.57465933809421</c:v>
                </c:pt>
                <c:pt idx="213">
                  <c:v>3.5238498114472301</c:v>
                </c:pt>
                <c:pt idx="214">
                  <c:v>3.5193204137045</c:v>
                </c:pt>
                <c:pt idx="215">
                  <c:v>3.5071868577735499</c:v>
                </c:pt>
                <c:pt idx="216">
                  <c:v>3.5024431288900999</c:v>
                </c:pt>
                <c:pt idx="217">
                  <c:v>3.4970136938761098</c:v>
                </c:pt>
                <c:pt idx="218">
                  <c:v>3.4962378785691599</c:v>
                </c:pt>
                <c:pt idx="219">
                  <c:v>3.4792662097171401</c:v>
                </c:pt>
                <c:pt idx="220">
                  <c:v>3.4768193978327702</c:v>
                </c:pt>
                <c:pt idx="221">
                  <c:v>3.4761102780377202</c:v>
                </c:pt>
                <c:pt idx="222">
                  <c:v>3.4543698623543699</c:v>
                </c:pt>
                <c:pt idx="223">
                  <c:v>3.45124274285009</c:v>
                </c:pt>
                <c:pt idx="224">
                  <c:v>3.41511064998318</c:v>
                </c:pt>
                <c:pt idx="225">
                  <c:v>3.3977219854160698</c:v>
                </c:pt>
                <c:pt idx="226">
                  <c:v>3.36366072785547</c:v>
                </c:pt>
                <c:pt idx="227">
                  <c:v>3.30941401865342</c:v>
                </c:pt>
                <c:pt idx="228">
                  <c:v>3.3079000425037601</c:v>
                </c:pt>
                <c:pt idx="229">
                  <c:v>3.2820753591509702</c:v>
                </c:pt>
                <c:pt idx="230">
                  <c:v>3.2606876158063001</c:v>
                </c:pt>
                <c:pt idx="231">
                  <c:v>3.2545309677051799</c:v>
                </c:pt>
                <c:pt idx="232">
                  <c:v>3.2443476351324398</c:v>
                </c:pt>
                <c:pt idx="233">
                  <c:v>3.2361486655960898</c:v>
                </c:pt>
                <c:pt idx="234">
                  <c:v>3.1908597924106501</c:v>
                </c:pt>
                <c:pt idx="235">
                  <c:v>3.1877409771899501</c:v>
                </c:pt>
                <c:pt idx="236">
                  <c:v>3.1737786232138498</c:v>
                </c:pt>
                <c:pt idx="237">
                  <c:v>3.1557671801843199</c:v>
                </c:pt>
                <c:pt idx="238">
                  <c:v>3.1541531025448299</c:v>
                </c:pt>
                <c:pt idx="239">
                  <c:v>3.1511168981239401</c:v>
                </c:pt>
                <c:pt idx="240">
                  <c:v>3.1104394723301199</c:v>
                </c:pt>
                <c:pt idx="241">
                  <c:v>3.0823477804824702</c:v>
                </c:pt>
                <c:pt idx="242">
                  <c:v>3.0556111621649902</c:v>
                </c:pt>
                <c:pt idx="243">
                  <c:v>3.0082876605884001</c:v>
                </c:pt>
                <c:pt idx="244">
                  <c:v>2.9905073604219301</c:v>
                </c:pt>
                <c:pt idx="245">
                  <c:v>2.9781821637356498</c:v>
                </c:pt>
                <c:pt idx="246">
                  <c:v>2.9613930108636102</c:v>
                </c:pt>
                <c:pt idx="247">
                  <c:v>2.9452636578315401</c:v>
                </c:pt>
                <c:pt idx="248">
                  <c:v>2.9313348615077901</c:v>
                </c:pt>
                <c:pt idx="249">
                  <c:v>2.9091785125787899</c:v>
                </c:pt>
                <c:pt idx="250">
                  <c:v>2.9062006011439498</c:v>
                </c:pt>
                <c:pt idx="251">
                  <c:v>2.8746236148473501</c:v>
                </c:pt>
                <c:pt idx="252">
                  <c:v>2.8637861166068701</c:v>
                </c:pt>
                <c:pt idx="253">
                  <c:v>2.8501319589528702</c:v>
                </c:pt>
                <c:pt idx="254">
                  <c:v>2.8394450775787399</c:v>
                </c:pt>
                <c:pt idx="255">
                  <c:v>2.8084903286427298</c:v>
                </c:pt>
                <c:pt idx="256">
                  <c:v>2.7284316834493798</c:v>
                </c:pt>
                <c:pt idx="257">
                  <c:v>2.7219108330880299</c:v>
                </c:pt>
                <c:pt idx="258">
                  <c:v>2.70706758250877</c:v>
                </c:pt>
                <c:pt idx="259">
                  <c:v>2.6857310169320701</c:v>
                </c:pt>
                <c:pt idx="260">
                  <c:v>2.67299692575319</c:v>
                </c:pt>
                <c:pt idx="261">
                  <c:v>2.66837182491243</c:v>
                </c:pt>
                <c:pt idx="262">
                  <c:v>2.6623297755750199</c:v>
                </c:pt>
                <c:pt idx="263">
                  <c:v>2.6601642021223801</c:v>
                </c:pt>
                <c:pt idx="264">
                  <c:v>2.6551581791760901</c:v>
                </c:pt>
                <c:pt idx="265">
                  <c:v>2.6496909965846598</c:v>
                </c:pt>
                <c:pt idx="266">
                  <c:v>2.6250309391351401</c:v>
                </c:pt>
                <c:pt idx="267">
                  <c:v>2.5820652393994301</c:v>
                </c:pt>
                <c:pt idx="268">
                  <c:v>2.5485248753090599</c:v>
                </c:pt>
                <c:pt idx="269">
                  <c:v>2.5403809821013201</c:v>
                </c:pt>
                <c:pt idx="270">
                  <c:v>2.5272847489247798</c:v>
                </c:pt>
                <c:pt idx="271">
                  <c:v>2.4919196791521201</c:v>
                </c:pt>
                <c:pt idx="272">
                  <c:v>2.4683899727723202</c:v>
                </c:pt>
                <c:pt idx="273">
                  <c:v>2.4633615353885499</c:v>
                </c:pt>
                <c:pt idx="274">
                  <c:v>2.4478845063220098</c:v>
                </c:pt>
                <c:pt idx="275">
                  <c:v>2.4220898529897998</c:v>
                </c:pt>
                <c:pt idx="276">
                  <c:v>2.4184023351611699</c:v>
                </c:pt>
                <c:pt idx="277">
                  <c:v>2.4124065365109999</c:v>
                </c:pt>
                <c:pt idx="278">
                  <c:v>2.40144849454368</c:v>
                </c:pt>
                <c:pt idx="279">
                  <c:v>2.3954965473226002</c:v>
                </c:pt>
                <c:pt idx="280">
                  <c:v>2.3939281965106298</c:v>
                </c:pt>
                <c:pt idx="281">
                  <c:v>2.3817119553672201</c:v>
                </c:pt>
                <c:pt idx="282">
                  <c:v>2.3382012486575898</c:v>
                </c:pt>
                <c:pt idx="283">
                  <c:v>2.29456914712613</c:v>
                </c:pt>
                <c:pt idx="284">
                  <c:v>2.2669992248763502</c:v>
                </c:pt>
                <c:pt idx="285">
                  <c:v>2.2668421946721198</c:v>
                </c:pt>
                <c:pt idx="286">
                  <c:v>2.2495677252613899</c:v>
                </c:pt>
                <c:pt idx="287">
                  <c:v>2.2348429628522299</c:v>
                </c:pt>
                <c:pt idx="288">
                  <c:v>2.23449374615952</c:v>
                </c:pt>
                <c:pt idx="289">
                  <c:v>2.23362450285763</c:v>
                </c:pt>
                <c:pt idx="290">
                  <c:v>2.2308252513421198</c:v>
                </c:pt>
                <c:pt idx="291">
                  <c:v>2.2182024825784001</c:v>
                </c:pt>
                <c:pt idx="292">
                  <c:v>2.21702356166753</c:v>
                </c:pt>
                <c:pt idx="293">
                  <c:v>2.2076233361469999</c:v>
                </c:pt>
                <c:pt idx="294">
                  <c:v>2.1928010533825799</c:v>
                </c:pt>
                <c:pt idx="295">
                  <c:v>2.1614576597188502</c:v>
                </c:pt>
                <c:pt idx="296">
                  <c:v>2.1514342078692801</c:v>
                </c:pt>
                <c:pt idx="297">
                  <c:v>2.1408538635213601</c:v>
                </c:pt>
                <c:pt idx="298">
                  <c:v>2.1235649140584099</c:v>
                </c:pt>
                <c:pt idx="299">
                  <c:v>2.1121943626809201</c:v>
                </c:pt>
                <c:pt idx="300">
                  <c:v>2.1023909359026498</c:v>
                </c:pt>
                <c:pt idx="301">
                  <c:v>2.0982954460905501</c:v>
                </c:pt>
                <c:pt idx="302">
                  <c:v>2.0962051500527901</c:v>
                </c:pt>
                <c:pt idx="303">
                  <c:v>2.0904377897576798</c:v>
                </c:pt>
                <c:pt idx="304">
                  <c:v>2.0710734320101301</c:v>
                </c:pt>
                <c:pt idx="305">
                  <c:v>2.0501754254319602</c:v>
                </c:pt>
                <c:pt idx="306">
                  <c:v>2.05015654100389</c:v>
                </c:pt>
                <c:pt idx="307">
                  <c:v>2.0491335004096198</c:v>
                </c:pt>
                <c:pt idx="308">
                  <c:v>2.0487739550885502</c:v>
                </c:pt>
                <c:pt idx="309">
                  <c:v>2.0427058327268601</c:v>
                </c:pt>
                <c:pt idx="310">
                  <c:v>2.0231936528069099</c:v>
                </c:pt>
                <c:pt idx="311">
                  <c:v>2.01297876279743</c:v>
                </c:pt>
                <c:pt idx="312">
                  <c:v>2.0115211842726302</c:v>
                </c:pt>
                <c:pt idx="313">
                  <c:v>1.9864468373402899</c:v>
                </c:pt>
                <c:pt idx="314">
                  <c:v>1.9814445076632099</c:v>
                </c:pt>
                <c:pt idx="315">
                  <c:v>1.96774421395673</c:v>
                </c:pt>
                <c:pt idx="316">
                  <c:v>1.95291836599813</c:v>
                </c:pt>
                <c:pt idx="317">
                  <c:v>1.9508944661252801</c:v>
                </c:pt>
                <c:pt idx="318">
                  <c:v>1.93419402225336</c:v>
                </c:pt>
                <c:pt idx="319">
                  <c:v>1.9340761614653801</c:v>
                </c:pt>
                <c:pt idx="320">
                  <c:v>1.92457394815797</c:v>
                </c:pt>
                <c:pt idx="321">
                  <c:v>1.92071929723146</c:v>
                </c:pt>
                <c:pt idx="322">
                  <c:v>1.91286799551683</c:v>
                </c:pt>
                <c:pt idx="323">
                  <c:v>1.9065021985132899</c:v>
                </c:pt>
                <c:pt idx="324">
                  <c:v>1.90568741959665</c:v>
                </c:pt>
                <c:pt idx="325">
                  <c:v>1.89489616178583</c:v>
                </c:pt>
                <c:pt idx="326">
                  <c:v>1.8836340049662199</c:v>
                </c:pt>
                <c:pt idx="327">
                  <c:v>1.87914278339782</c:v>
                </c:pt>
                <c:pt idx="328">
                  <c:v>1.8605796389376601</c:v>
                </c:pt>
                <c:pt idx="329">
                  <c:v>1.85099338972078</c:v>
                </c:pt>
                <c:pt idx="330">
                  <c:v>1.83849813917579</c:v>
                </c:pt>
                <c:pt idx="331">
                  <c:v>1.83373498395847</c:v>
                </c:pt>
                <c:pt idx="332">
                  <c:v>1.8253626495248301</c:v>
                </c:pt>
                <c:pt idx="333">
                  <c:v>1.805818477444</c:v>
                </c:pt>
                <c:pt idx="334">
                  <c:v>1.78158791499536</c:v>
                </c:pt>
                <c:pt idx="335">
                  <c:v>1.77045696807418</c:v>
                </c:pt>
                <c:pt idx="336">
                  <c:v>1.7673147657097401</c:v>
                </c:pt>
                <c:pt idx="337">
                  <c:v>1.7632587250959</c:v>
                </c:pt>
                <c:pt idx="338">
                  <c:v>1.7535650721284799</c:v>
                </c:pt>
                <c:pt idx="339">
                  <c:v>1.74510083145341</c:v>
                </c:pt>
                <c:pt idx="340">
                  <c:v>1.74257381230977</c:v>
                </c:pt>
                <c:pt idx="341">
                  <c:v>1.7275363629242699</c:v>
                </c:pt>
                <c:pt idx="342">
                  <c:v>1.72630920566278</c:v>
                </c:pt>
                <c:pt idx="343">
                  <c:v>1.72095006425019</c:v>
                </c:pt>
                <c:pt idx="344">
                  <c:v>1.70841276213312</c:v>
                </c:pt>
                <c:pt idx="345">
                  <c:v>1.7058674894436301</c:v>
                </c:pt>
                <c:pt idx="346">
                  <c:v>1.6917342879622601</c:v>
                </c:pt>
                <c:pt idx="347">
                  <c:v>1.66504223501781</c:v>
                </c:pt>
                <c:pt idx="348">
                  <c:v>1.65430043620554</c:v>
                </c:pt>
                <c:pt idx="349">
                  <c:v>1.6518780526777099</c:v>
                </c:pt>
                <c:pt idx="350">
                  <c:v>1.6420950820117299</c:v>
                </c:pt>
                <c:pt idx="351">
                  <c:v>1.6381867279548299</c:v>
                </c:pt>
                <c:pt idx="352">
                  <c:v>1.6292524610589501</c:v>
                </c:pt>
                <c:pt idx="353">
                  <c:v>1.6244981598888699</c:v>
                </c:pt>
                <c:pt idx="354">
                  <c:v>1.61163868279393</c:v>
                </c:pt>
                <c:pt idx="355">
                  <c:v>1.6062998000325801</c:v>
                </c:pt>
                <c:pt idx="356">
                  <c:v>1.6033865262459599</c:v>
                </c:pt>
                <c:pt idx="357">
                  <c:v>1.5983440146064301</c:v>
                </c:pt>
                <c:pt idx="358">
                  <c:v>1.5872054909345501</c:v>
                </c:pt>
                <c:pt idx="359">
                  <c:v>1.5743385076406899</c:v>
                </c:pt>
                <c:pt idx="360">
                  <c:v>1.5717595802851601</c:v>
                </c:pt>
                <c:pt idx="361">
                  <c:v>1.56258211231597</c:v>
                </c:pt>
                <c:pt idx="362">
                  <c:v>1.55751537836887</c:v>
                </c:pt>
                <c:pt idx="363">
                  <c:v>1.5524405705840001</c:v>
                </c:pt>
                <c:pt idx="364">
                  <c:v>1.5504130979153401</c:v>
                </c:pt>
                <c:pt idx="365">
                  <c:v>1.54819043206776</c:v>
                </c:pt>
                <c:pt idx="366">
                  <c:v>1.5464303496477401</c:v>
                </c:pt>
                <c:pt idx="367">
                  <c:v>1.5330925060973599</c:v>
                </c:pt>
                <c:pt idx="368">
                  <c:v>1.5097754585660099</c:v>
                </c:pt>
                <c:pt idx="369">
                  <c:v>1.50926648814582</c:v>
                </c:pt>
                <c:pt idx="370">
                  <c:v>1.50906278204227</c:v>
                </c:pt>
                <c:pt idx="371">
                  <c:v>1.5057124750214601</c:v>
                </c:pt>
                <c:pt idx="372">
                  <c:v>1.50538732072244</c:v>
                </c:pt>
                <c:pt idx="373">
                  <c:v>1.5050626619546701</c:v>
                </c:pt>
                <c:pt idx="374">
                  <c:v>1.49731762284922</c:v>
                </c:pt>
                <c:pt idx="375">
                  <c:v>1.49512925167982</c:v>
                </c:pt>
                <c:pt idx="376">
                  <c:v>1.4855900379731899</c:v>
                </c:pt>
                <c:pt idx="377">
                  <c:v>1.47768301035813</c:v>
                </c:pt>
                <c:pt idx="378">
                  <c:v>1.4720719927179999</c:v>
                </c:pt>
                <c:pt idx="379">
                  <c:v>1.46842782437527</c:v>
                </c:pt>
                <c:pt idx="380">
                  <c:v>1.4608460999681001</c:v>
                </c:pt>
                <c:pt idx="381">
                  <c:v>1.4581609043353401</c:v>
                </c:pt>
                <c:pt idx="382">
                  <c:v>1.4526793691684301</c:v>
                </c:pt>
                <c:pt idx="383">
                  <c:v>1.44450733015166</c:v>
                </c:pt>
                <c:pt idx="384">
                  <c:v>1.4432195095684199</c:v>
                </c:pt>
                <c:pt idx="385">
                  <c:v>1.4413012831790499</c:v>
                </c:pt>
                <c:pt idx="386">
                  <c:v>1.4181439779082601</c:v>
                </c:pt>
                <c:pt idx="387">
                  <c:v>1.40221320848957</c:v>
                </c:pt>
                <c:pt idx="388">
                  <c:v>1.3942798874896301</c:v>
                </c:pt>
                <c:pt idx="389">
                  <c:v>1.3826336506916299</c:v>
                </c:pt>
                <c:pt idx="390">
                  <c:v>1.38192828202642</c:v>
                </c:pt>
                <c:pt idx="391">
                  <c:v>1.3728813871007199</c:v>
                </c:pt>
                <c:pt idx="392">
                  <c:v>1.3624358166781301</c:v>
                </c:pt>
                <c:pt idx="393">
                  <c:v>1.3577666823855801</c:v>
                </c:pt>
                <c:pt idx="394">
                  <c:v>1.3568775177504999</c:v>
                </c:pt>
                <c:pt idx="395">
                  <c:v>1.3427645062869</c:v>
                </c:pt>
                <c:pt idx="396">
                  <c:v>1.3300992172673201</c:v>
                </c:pt>
                <c:pt idx="397">
                  <c:v>1.3293193346361001</c:v>
                </c:pt>
                <c:pt idx="398">
                  <c:v>1.3242857404306001</c:v>
                </c:pt>
                <c:pt idx="399">
                  <c:v>1.3225011853497199</c:v>
                </c:pt>
                <c:pt idx="400">
                  <c:v>1.30819903481432</c:v>
                </c:pt>
                <c:pt idx="401">
                  <c:v>1.3000576966764501</c:v>
                </c:pt>
                <c:pt idx="402">
                  <c:v>1.29896628304214</c:v>
                </c:pt>
                <c:pt idx="403">
                  <c:v>1.2862519528309699</c:v>
                </c:pt>
                <c:pt idx="404">
                  <c:v>1.28270121022937</c:v>
                </c:pt>
                <c:pt idx="405">
                  <c:v>1.2820913388495201</c:v>
                </c:pt>
                <c:pt idx="406">
                  <c:v>1.27857100336572</c:v>
                </c:pt>
                <c:pt idx="407">
                  <c:v>1.27386634272201</c:v>
                </c:pt>
                <c:pt idx="408">
                  <c:v>1.26743579952115</c:v>
                </c:pt>
                <c:pt idx="409">
                  <c:v>1.26519754938978</c:v>
                </c:pt>
                <c:pt idx="410">
                  <c:v>1.2555441816904001</c:v>
                </c:pt>
                <c:pt idx="411">
                  <c:v>1.2445875922994101</c:v>
                </c:pt>
                <c:pt idx="412">
                  <c:v>1.24243301736027</c:v>
                </c:pt>
                <c:pt idx="413">
                  <c:v>1.24139179490607</c:v>
                </c:pt>
                <c:pt idx="414">
                  <c:v>1.23510545390046</c:v>
                </c:pt>
                <c:pt idx="415">
                  <c:v>1.2347698984140201</c:v>
                </c:pt>
                <c:pt idx="416">
                  <c:v>1.2190564606085801</c:v>
                </c:pt>
                <c:pt idx="417">
                  <c:v>1.21284758163491</c:v>
                </c:pt>
                <c:pt idx="418">
                  <c:v>1.21078152785673</c:v>
                </c:pt>
                <c:pt idx="419">
                  <c:v>1.19270116737403</c:v>
                </c:pt>
                <c:pt idx="420">
                  <c:v>1.17644768332715</c:v>
                </c:pt>
                <c:pt idx="421">
                  <c:v>1.17575874058809</c:v>
                </c:pt>
                <c:pt idx="422">
                  <c:v>1.1725514799957499</c:v>
                </c:pt>
                <c:pt idx="423">
                  <c:v>1.1518228768782599</c:v>
                </c:pt>
                <c:pt idx="424">
                  <c:v>1.1509807251636499</c:v>
                </c:pt>
                <c:pt idx="425">
                  <c:v>1.15080842848637</c:v>
                </c:pt>
                <c:pt idx="426">
                  <c:v>1.1497400742678801</c:v>
                </c:pt>
                <c:pt idx="427">
                  <c:v>1.14178772852365</c:v>
                </c:pt>
                <c:pt idx="428">
                  <c:v>1.13915387934694</c:v>
                </c:pt>
                <c:pt idx="429">
                  <c:v>1.1377228850545</c:v>
                </c:pt>
                <c:pt idx="430">
                  <c:v>1.1233076362258201</c:v>
                </c:pt>
                <c:pt idx="431">
                  <c:v>1.1113643796771</c:v>
                </c:pt>
                <c:pt idx="432">
                  <c:v>1.11125881851093</c:v>
                </c:pt>
                <c:pt idx="433">
                  <c:v>1.1053093180951401</c:v>
                </c:pt>
                <c:pt idx="434">
                  <c:v>1.1017274462125899</c:v>
                </c:pt>
                <c:pt idx="435">
                  <c:v>1.09695314400946</c:v>
                </c:pt>
                <c:pt idx="436">
                  <c:v>1.0772478617182799</c:v>
                </c:pt>
                <c:pt idx="437">
                  <c:v>1.0761021169418099</c:v>
                </c:pt>
                <c:pt idx="438">
                  <c:v>1.0628118438699801</c:v>
                </c:pt>
                <c:pt idx="439">
                  <c:v>1.0609893635548699</c:v>
                </c:pt>
                <c:pt idx="440">
                  <c:v>1.0326367518873201</c:v>
                </c:pt>
                <c:pt idx="441">
                  <c:v>1.02639155786474</c:v>
                </c:pt>
                <c:pt idx="442">
                  <c:v>1.0228039371554001</c:v>
                </c:pt>
                <c:pt idx="443">
                  <c:v>1.01308884388479</c:v>
                </c:pt>
                <c:pt idx="444">
                  <c:v>1.0046852593759199</c:v>
                </c:pt>
                <c:pt idx="445">
                  <c:v>1.0006013166280401</c:v>
                </c:pt>
              </c:numCache>
            </c:numRef>
          </c:xVal>
          <c:yVal>
            <c:numRef>
              <c:f>Sheet1!$P$3:$P$448</c:f>
              <c:numCache>
                <c:formatCode>General</c:formatCode>
                <c:ptCount val="446"/>
                <c:pt idx="0">
                  <c:v>9.9999999999999997E-61</c:v>
                </c:pt>
                <c:pt idx="1">
                  <c:v>7.9200000000000003E-99</c:v>
                </c:pt>
                <c:pt idx="2">
                  <c:v>3.3700000000000002E-62</c:v>
                </c:pt>
                <c:pt idx="3">
                  <c:v>5.8599999999999995E-76</c:v>
                </c:pt>
                <c:pt idx="4">
                  <c:v>6.7800000000000001E-117</c:v>
                </c:pt>
                <c:pt idx="5">
                  <c:v>9.7600000000000004E-110</c:v>
                </c:pt>
                <c:pt idx="6">
                  <c:v>2.1799999999999999E-114</c:v>
                </c:pt>
                <c:pt idx="7">
                  <c:v>2.0899999999999999E-42</c:v>
                </c:pt>
                <c:pt idx="8">
                  <c:v>1.17E-84</c:v>
                </c:pt>
                <c:pt idx="9">
                  <c:v>5.6899999999999997E-130</c:v>
                </c:pt>
                <c:pt idx="10">
                  <c:v>1.97E-32</c:v>
                </c:pt>
                <c:pt idx="11">
                  <c:v>8.18E-85</c:v>
                </c:pt>
                <c:pt idx="12">
                  <c:v>5.1499999999999997E-23</c:v>
                </c:pt>
                <c:pt idx="13">
                  <c:v>2.94E-110</c:v>
                </c:pt>
                <c:pt idx="14">
                  <c:v>2.9900000000000003E-17</c:v>
                </c:pt>
                <c:pt idx="15">
                  <c:v>2.0200000000000001E-73</c:v>
                </c:pt>
                <c:pt idx="16">
                  <c:v>1.4299999999999999E-17</c:v>
                </c:pt>
                <c:pt idx="17">
                  <c:v>6.7499999999999996E-99</c:v>
                </c:pt>
                <c:pt idx="18">
                  <c:v>4.4000000000000001E-33</c:v>
                </c:pt>
                <c:pt idx="19">
                  <c:v>5.5900000000000004E-85</c:v>
                </c:pt>
                <c:pt idx="20">
                  <c:v>2.89E-40</c:v>
                </c:pt>
                <c:pt idx="21">
                  <c:v>1.7900000000000001E-68</c:v>
                </c:pt>
                <c:pt idx="22">
                  <c:v>2.8699999999999999E-46</c:v>
                </c:pt>
                <c:pt idx="23">
                  <c:v>1.0399999999999999E-15</c:v>
                </c:pt>
                <c:pt idx="24">
                  <c:v>3.5800000000000001E-56</c:v>
                </c:pt>
                <c:pt idx="25">
                  <c:v>9.2200000000000003E-90</c:v>
                </c:pt>
                <c:pt idx="26">
                  <c:v>2.17E-69</c:v>
                </c:pt>
                <c:pt idx="27">
                  <c:v>2.2399999999999998E-68</c:v>
                </c:pt>
                <c:pt idx="28">
                  <c:v>7.3599999999999999E-35</c:v>
                </c:pt>
                <c:pt idx="29">
                  <c:v>1.03E-15</c:v>
                </c:pt>
                <c:pt idx="30">
                  <c:v>5.88E-27</c:v>
                </c:pt>
                <c:pt idx="31">
                  <c:v>1.92E-66</c:v>
                </c:pt>
                <c:pt idx="32">
                  <c:v>1.82E-26</c:v>
                </c:pt>
                <c:pt idx="33">
                  <c:v>2.8800000000000001E-71</c:v>
                </c:pt>
                <c:pt idx="34">
                  <c:v>4.0500000000000001E-81</c:v>
                </c:pt>
                <c:pt idx="35">
                  <c:v>5.0900000000000004E-28</c:v>
                </c:pt>
                <c:pt idx="36">
                  <c:v>1.34E-27</c:v>
                </c:pt>
                <c:pt idx="37">
                  <c:v>1.8899999999999999E-31</c:v>
                </c:pt>
                <c:pt idx="38">
                  <c:v>8.5900000000000004E-43</c:v>
                </c:pt>
                <c:pt idx="39">
                  <c:v>3.2299999999999999E-19</c:v>
                </c:pt>
                <c:pt idx="40">
                  <c:v>1.7500000000000001E-19</c:v>
                </c:pt>
                <c:pt idx="41">
                  <c:v>2.9200000000000002E-29</c:v>
                </c:pt>
                <c:pt idx="42">
                  <c:v>4.5892936503161102E-92</c:v>
                </c:pt>
                <c:pt idx="43">
                  <c:v>2.9599999999999998E-51</c:v>
                </c:pt>
                <c:pt idx="44">
                  <c:v>8.7900000000000004E-26</c:v>
                </c:pt>
                <c:pt idx="45">
                  <c:v>6.6800000000000001E-71</c:v>
                </c:pt>
                <c:pt idx="46">
                  <c:v>1.6499999999999999E-34</c:v>
                </c:pt>
                <c:pt idx="47">
                  <c:v>1.5999999999999999E-22</c:v>
                </c:pt>
                <c:pt idx="48">
                  <c:v>2.1200000000000001E-59</c:v>
                </c:pt>
                <c:pt idx="49">
                  <c:v>2.4E-33</c:v>
                </c:pt>
                <c:pt idx="50">
                  <c:v>9.4500000000000001E-66</c:v>
                </c:pt>
                <c:pt idx="51">
                  <c:v>3.6900000000000002E-32</c:v>
                </c:pt>
                <c:pt idx="52">
                  <c:v>4.2600000000000002E-48</c:v>
                </c:pt>
                <c:pt idx="53">
                  <c:v>1.6499999999999999E-34</c:v>
                </c:pt>
                <c:pt idx="54">
                  <c:v>4.8499999999999998E-48</c:v>
                </c:pt>
                <c:pt idx="55">
                  <c:v>2.8799999999999998E-48</c:v>
                </c:pt>
                <c:pt idx="56">
                  <c:v>6.7599999999999997E-43</c:v>
                </c:pt>
                <c:pt idx="57">
                  <c:v>2.0700000000000001E-44</c:v>
                </c:pt>
                <c:pt idx="58">
                  <c:v>2.0000000000000001E-62</c:v>
                </c:pt>
                <c:pt idx="59">
                  <c:v>1.42E-21</c:v>
                </c:pt>
                <c:pt idx="60">
                  <c:v>6.7500000000000002E-25</c:v>
                </c:pt>
                <c:pt idx="61">
                  <c:v>1.56E-57</c:v>
                </c:pt>
                <c:pt idx="62">
                  <c:v>2.0900000000000001E-47</c:v>
                </c:pt>
                <c:pt idx="63">
                  <c:v>1.43E-55</c:v>
                </c:pt>
                <c:pt idx="64">
                  <c:v>1.34E-41</c:v>
                </c:pt>
                <c:pt idx="65">
                  <c:v>6.44E-52</c:v>
                </c:pt>
                <c:pt idx="66">
                  <c:v>2.26E-35</c:v>
                </c:pt>
                <c:pt idx="67">
                  <c:v>2.4699999999999999E-77</c:v>
                </c:pt>
                <c:pt idx="68">
                  <c:v>4.3400000000000001E-35</c:v>
                </c:pt>
                <c:pt idx="69">
                  <c:v>2.2899999999999999E-25</c:v>
                </c:pt>
                <c:pt idx="70">
                  <c:v>5.3199999999999997E-21</c:v>
                </c:pt>
                <c:pt idx="71">
                  <c:v>6.3100000000000005E-57</c:v>
                </c:pt>
                <c:pt idx="72">
                  <c:v>2.06E-50</c:v>
                </c:pt>
                <c:pt idx="73">
                  <c:v>7.3E-34</c:v>
                </c:pt>
                <c:pt idx="74">
                  <c:v>1.2E-61</c:v>
                </c:pt>
                <c:pt idx="75">
                  <c:v>1.45E-9</c:v>
                </c:pt>
                <c:pt idx="76">
                  <c:v>1.9600000000000001E-43</c:v>
                </c:pt>
                <c:pt idx="77">
                  <c:v>3.8899999999999998E-28</c:v>
                </c:pt>
                <c:pt idx="78">
                  <c:v>9.3300000000000005E-45</c:v>
                </c:pt>
                <c:pt idx="79">
                  <c:v>2.9200000000000001E-51</c:v>
                </c:pt>
                <c:pt idx="80">
                  <c:v>2.6399999999999999E-24</c:v>
                </c:pt>
                <c:pt idx="81">
                  <c:v>1.11E-33</c:v>
                </c:pt>
                <c:pt idx="82">
                  <c:v>2.8399999999999998E-35</c:v>
                </c:pt>
                <c:pt idx="83">
                  <c:v>4.4900000000000003E-50</c:v>
                </c:pt>
                <c:pt idx="84">
                  <c:v>8.1599999999999998E-51</c:v>
                </c:pt>
                <c:pt idx="85">
                  <c:v>3.94E-51</c:v>
                </c:pt>
                <c:pt idx="86">
                  <c:v>2.59E-33</c:v>
                </c:pt>
                <c:pt idx="87">
                  <c:v>8.4700000000000002E-33</c:v>
                </c:pt>
                <c:pt idx="88">
                  <c:v>1.42E-27</c:v>
                </c:pt>
                <c:pt idx="89">
                  <c:v>3.1699999999999999E-8</c:v>
                </c:pt>
                <c:pt idx="90">
                  <c:v>2.1199999999999999E-43</c:v>
                </c:pt>
                <c:pt idx="91">
                  <c:v>1.5400000000000001E-57</c:v>
                </c:pt>
                <c:pt idx="92">
                  <c:v>4.35E-18</c:v>
                </c:pt>
                <c:pt idx="93">
                  <c:v>1.6000000000000001E-17</c:v>
                </c:pt>
                <c:pt idx="94">
                  <c:v>1.31E-24</c:v>
                </c:pt>
                <c:pt idx="95">
                  <c:v>1.9500000000000001E-50</c:v>
                </c:pt>
                <c:pt idx="96">
                  <c:v>8E-14</c:v>
                </c:pt>
                <c:pt idx="97">
                  <c:v>4.1699999999999999E-31</c:v>
                </c:pt>
                <c:pt idx="98">
                  <c:v>1.0799999999999999E-50</c:v>
                </c:pt>
                <c:pt idx="99">
                  <c:v>4.9399999999999997E-21</c:v>
                </c:pt>
                <c:pt idx="100">
                  <c:v>3.2099999999999999E-18</c:v>
                </c:pt>
                <c:pt idx="101">
                  <c:v>9.39E-21</c:v>
                </c:pt>
                <c:pt idx="102">
                  <c:v>1.1599999999999999E-23</c:v>
                </c:pt>
                <c:pt idx="103">
                  <c:v>1.52E-49</c:v>
                </c:pt>
                <c:pt idx="104">
                  <c:v>2.73E-34</c:v>
                </c:pt>
                <c:pt idx="105">
                  <c:v>1.91E-35</c:v>
                </c:pt>
                <c:pt idx="106">
                  <c:v>8.9300000000000005E-31</c:v>
                </c:pt>
                <c:pt idx="107">
                  <c:v>3.0999999999999999E-30</c:v>
                </c:pt>
                <c:pt idx="108">
                  <c:v>4.1499999999999997E-26</c:v>
                </c:pt>
                <c:pt idx="109">
                  <c:v>3.8400000000000004E-37</c:v>
                </c:pt>
                <c:pt idx="110">
                  <c:v>2.0699999999999999E-26</c:v>
                </c:pt>
                <c:pt idx="111">
                  <c:v>2.6600000000000002E-19</c:v>
                </c:pt>
                <c:pt idx="112">
                  <c:v>3.2900000000000002E-17</c:v>
                </c:pt>
                <c:pt idx="113">
                  <c:v>1.4999999999999999E-25</c:v>
                </c:pt>
                <c:pt idx="114">
                  <c:v>5.4800000000000001E-25</c:v>
                </c:pt>
                <c:pt idx="115">
                  <c:v>1.42E-48</c:v>
                </c:pt>
                <c:pt idx="116">
                  <c:v>9.9200000000000003E-39</c:v>
                </c:pt>
                <c:pt idx="117">
                  <c:v>1.31E-25</c:v>
                </c:pt>
                <c:pt idx="118">
                  <c:v>6.98E-31</c:v>
                </c:pt>
                <c:pt idx="119">
                  <c:v>1.16E-26</c:v>
                </c:pt>
                <c:pt idx="120">
                  <c:v>1.3300000000000001E-28</c:v>
                </c:pt>
                <c:pt idx="121">
                  <c:v>2.2999999999999999E-33</c:v>
                </c:pt>
                <c:pt idx="122">
                  <c:v>1.3599999999999999E-31</c:v>
                </c:pt>
                <c:pt idx="123">
                  <c:v>3.4000000000000001E-31</c:v>
                </c:pt>
                <c:pt idx="124">
                  <c:v>2.5099999999999999E-34</c:v>
                </c:pt>
                <c:pt idx="125">
                  <c:v>3.62E-38</c:v>
                </c:pt>
                <c:pt idx="126">
                  <c:v>4.0099999999999997E-35</c:v>
                </c:pt>
                <c:pt idx="127">
                  <c:v>3.0300000000000001E-28</c:v>
                </c:pt>
                <c:pt idx="128">
                  <c:v>1.3E-22</c:v>
                </c:pt>
                <c:pt idx="129">
                  <c:v>2.5300000000000001E-45</c:v>
                </c:pt>
                <c:pt idx="130">
                  <c:v>6.0399999999999995E-38</c:v>
                </c:pt>
                <c:pt idx="131">
                  <c:v>3.5400000000000001E-31</c:v>
                </c:pt>
                <c:pt idx="132">
                  <c:v>1.5699999999999999E-25</c:v>
                </c:pt>
                <c:pt idx="133">
                  <c:v>4.3100000000000002E-18</c:v>
                </c:pt>
                <c:pt idx="134">
                  <c:v>2.58E-30</c:v>
                </c:pt>
                <c:pt idx="135">
                  <c:v>5.6399999999999998E-14</c:v>
                </c:pt>
                <c:pt idx="136">
                  <c:v>1.8599999999999999E-15</c:v>
                </c:pt>
                <c:pt idx="137">
                  <c:v>1.52E-16</c:v>
                </c:pt>
                <c:pt idx="138">
                  <c:v>1.1E-14</c:v>
                </c:pt>
                <c:pt idx="139">
                  <c:v>5.83E-33</c:v>
                </c:pt>
                <c:pt idx="140">
                  <c:v>1.7399999999999999E-21</c:v>
                </c:pt>
                <c:pt idx="141">
                  <c:v>1.3799999999999999E-22</c:v>
                </c:pt>
                <c:pt idx="142">
                  <c:v>3.5099999999999997E-27</c:v>
                </c:pt>
                <c:pt idx="143">
                  <c:v>9.1800000000000005E-18</c:v>
                </c:pt>
                <c:pt idx="144">
                  <c:v>2.2499999999999999E-26</c:v>
                </c:pt>
                <c:pt idx="145">
                  <c:v>1.4799999999999999E-23</c:v>
                </c:pt>
                <c:pt idx="146">
                  <c:v>1.4299999999999999E-35</c:v>
                </c:pt>
                <c:pt idx="147">
                  <c:v>5.2499999999999996E-12</c:v>
                </c:pt>
                <c:pt idx="148">
                  <c:v>3.81E-29</c:v>
                </c:pt>
                <c:pt idx="149">
                  <c:v>1.17E-38</c:v>
                </c:pt>
                <c:pt idx="150">
                  <c:v>1.1099999999999999E-21</c:v>
                </c:pt>
                <c:pt idx="151">
                  <c:v>2.8600000000000001E-6</c:v>
                </c:pt>
                <c:pt idx="152">
                  <c:v>9.9299999999999998E-35</c:v>
                </c:pt>
                <c:pt idx="153">
                  <c:v>5.4900000000000002E-17</c:v>
                </c:pt>
                <c:pt idx="154">
                  <c:v>6.3799999999999998E-21</c:v>
                </c:pt>
                <c:pt idx="155">
                  <c:v>2.5900000000000001E-34</c:v>
                </c:pt>
                <c:pt idx="156">
                  <c:v>5.9700000000000001E-17</c:v>
                </c:pt>
                <c:pt idx="157">
                  <c:v>1.3800000000000001E-19</c:v>
                </c:pt>
                <c:pt idx="158">
                  <c:v>8.5400000000000001E-31</c:v>
                </c:pt>
                <c:pt idx="159">
                  <c:v>2.98E-35</c:v>
                </c:pt>
                <c:pt idx="160">
                  <c:v>3.6499999999999998E-28</c:v>
                </c:pt>
                <c:pt idx="161">
                  <c:v>1.62E-24</c:v>
                </c:pt>
                <c:pt idx="162">
                  <c:v>1.13E-15</c:v>
                </c:pt>
                <c:pt idx="163">
                  <c:v>1.4799999999999999E-4</c:v>
                </c:pt>
                <c:pt idx="164">
                  <c:v>6.8899999999999995E-16</c:v>
                </c:pt>
                <c:pt idx="165">
                  <c:v>1.1699999999999999E-25</c:v>
                </c:pt>
                <c:pt idx="166">
                  <c:v>1.59E-18</c:v>
                </c:pt>
                <c:pt idx="167">
                  <c:v>2.6200000000000001E-14</c:v>
                </c:pt>
                <c:pt idx="168">
                  <c:v>5.3199999999999999E-26</c:v>
                </c:pt>
                <c:pt idx="169">
                  <c:v>4.0000000000000001E-13</c:v>
                </c:pt>
                <c:pt idx="170">
                  <c:v>2.1699999999999999E-29</c:v>
                </c:pt>
                <c:pt idx="171">
                  <c:v>1.3099999999999999E-22</c:v>
                </c:pt>
                <c:pt idx="172">
                  <c:v>9.4000000000000001E-19</c:v>
                </c:pt>
                <c:pt idx="173">
                  <c:v>3.8500000000000003E-11</c:v>
                </c:pt>
                <c:pt idx="174">
                  <c:v>9.7899999999999993E-12</c:v>
                </c:pt>
                <c:pt idx="175">
                  <c:v>5.8299999999999997E-15</c:v>
                </c:pt>
                <c:pt idx="176">
                  <c:v>4.4099999999999998E-17</c:v>
                </c:pt>
                <c:pt idx="177">
                  <c:v>1.48E-19</c:v>
                </c:pt>
                <c:pt idx="178">
                  <c:v>1.04E-12</c:v>
                </c:pt>
                <c:pt idx="179">
                  <c:v>2.5100000000000001E-21</c:v>
                </c:pt>
                <c:pt idx="180">
                  <c:v>3.51E-24</c:v>
                </c:pt>
                <c:pt idx="181">
                  <c:v>7.7300000000000002E-20</c:v>
                </c:pt>
                <c:pt idx="182">
                  <c:v>4.2599999999999998E-17</c:v>
                </c:pt>
                <c:pt idx="183">
                  <c:v>1.6499999999999999E-16</c:v>
                </c:pt>
                <c:pt idx="184">
                  <c:v>3.0699999999999998E-19</c:v>
                </c:pt>
                <c:pt idx="185">
                  <c:v>5.0100000000000002E-20</c:v>
                </c:pt>
                <c:pt idx="186">
                  <c:v>4.6000000000000001E-4</c:v>
                </c:pt>
                <c:pt idx="187">
                  <c:v>4.7699999999999999E-9</c:v>
                </c:pt>
                <c:pt idx="188">
                  <c:v>1.35E-16</c:v>
                </c:pt>
                <c:pt idx="189">
                  <c:v>5.6499999999999998E-20</c:v>
                </c:pt>
                <c:pt idx="190">
                  <c:v>1.1200000000000001E-23</c:v>
                </c:pt>
                <c:pt idx="191">
                  <c:v>3.6799999999999998E-15</c:v>
                </c:pt>
                <c:pt idx="192">
                  <c:v>8.6499999999999995E-16</c:v>
                </c:pt>
                <c:pt idx="193">
                  <c:v>2.2900000000000002E-16</c:v>
                </c:pt>
                <c:pt idx="194">
                  <c:v>2.1400000000000001E-10</c:v>
                </c:pt>
                <c:pt idx="195">
                  <c:v>2.3599999999999998E-22</c:v>
                </c:pt>
                <c:pt idx="196">
                  <c:v>6.4900000000000001E-15</c:v>
                </c:pt>
                <c:pt idx="197">
                  <c:v>1.67E-13</c:v>
                </c:pt>
                <c:pt idx="198">
                  <c:v>3.6900000000000003E-11</c:v>
                </c:pt>
                <c:pt idx="199">
                  <c:v>6.5700000000000003E-16</c:v>
                </c:pt>
                <c:pt idx="200">
                  <c:v>7.3599999999999997E-14</c:v>
                </c:pt>
                <c:pt idx="201">
                  <c:v>3.3299999999999999E-13</c:v>
                </c:pt>
                <c:pt idx="202">
                  <c:v>1.8799999999999999E-14</c:v>
                </c:pt>
                <c:pt idx="203">
                  <c:v>5.1799999999999996E-19</c:v>
                </c:pt>
                <c:pt idx="204">
                  <c:v>1.18E-8</c:v>
                </c:pt>
                <c:pt idx="205">
                  <c:v>6.9700000000000004E-12</c:v>
                </c:pt>
                <c:pt idx="206">
                  <c:v>1.54E-20</c:v>
                </c:pt>
                <c:pt idx="207">
                  <c:v>1.0899999999999999E-11</c:v>
                </c:pt>
                <c:pt idx="208">
                  <c:v>9.1700000000000004E-11</c:v>
                </c:pt>
                <c:pt idx="209">
                  <c:v>3.6800000000000002E-10</c:v>
                </c:pt>
                <c:pt idx="210">
                  <c:v>3.7300000000000003E-15</c:v>
                </c:pt>
                <c:pt idx="211">
                  <c:v>7.54E-9</c:v>
                </c:pt>
                <c:pt idx="212">
                  <c:v>9.0499999999999998E-11</c:v>
                </c:pt>
                <c:pt idx="213">
                  <c:v>3.71E-11</c:v>
                </c:pt>
                <c:pt idx="214">
                  <c:v>1.4600000000000001E-16</c:v>
                </c:pt>
                <c:pt idx="215">
                  <c:v>2.67E-15</c:v>
                </c:pt>
                <c:pt idx="216">
                  <c:v>8.9399999999999996E-11</c:v>
                </c:pt>
                <c:pt idx="217">
                  <c:v>5.2699999999999999E-7</c:v>
                </c:pt>
                <c:pt idx="218">
                  <c:v>4.1099999999999996E-6</c:v>
                </c:pt>
                <c:pt idx="219">
                  <c:v>8.4600000000000007E-12</c:v>
                </c:pt>
                <c:pt idx="220">
                  <c:v>7.28E-15</c:v>
                </c:pt>
                <c:pt idx="221">
                  <c:v>2.4699999999999999E-8</c:v>
                </c:pt>
                <c:pt idx="222">
                  <c:v>1.0600000000000001E-9</c:v>
                </c:pt>
                <c:pt idx="223">
                  <c:v>2.11E-9</c:v>
                </c:pt>
                <c:pt idx="224">
                  <c:v>2.7999999999999999E-17</c:v>
                </c:pt>
                <c:pt idx="225">
                  <c:v>4.6199999999999999E-11</c:v>
                </c:pt>
                <c:pt idx="226">
                  <c:v>1.92E-7</c:v>
                </c:pt>
                <c:pt idx="227">
                  <c:v>5.95E-15</c:v>
                </c:pt>
                <c:pt idx="228">
                  <c:v>2.75E-14</c:v>
                </c:pt>
                <c:pt idx="229">
                  <c:v>3.2899999999999999E-12</c:v>
                </c:pt>
                <c:pt idx="230">
                  <c:v>3.6200000000000002E-17</c:v>
                </c:pt>
                <c:pt idx="231">
                  <c:v>2.2999999999999999E-9</c:v>
                </c:pt>
                <c:pt idx="232">
                  <c:v>2.8000000000000002E-12</c:v>
                </c:pt>
                <c:pt idx="233">
                  <c:v>3.39E-17</c:v>
                </c:pt>
                <c:pt idx="234">
                  <c:v>4.1399999999999999E-14</c:v>
                </c:pt>
                <c:pt idx="235">
                  <c:v>2.27E-14</c:v>
                </c:pt>
                <c:pt idx="236">
                  <c:v>4.2200000000000003E-5</c:v>
                </c:pt>
                <c:pt idx="237">
                  <c:v>1.2100000000000001E-12</c:v>
                </c:pt>
                <c:pt idx="238">
                  <c:v>3.1699999999999998E-15</c:v>
                </c:pt>
                <c:pt idx="239">
                  <c:v>4.42E-9</c:v>
                </c:pt>
                <c:pt idx="240">
                  <c:v>3.64E-15</c:v>
                </c:pt>
                <c:pt idx="241">
                  <c:v>8.5699999999999996E-5</c:v>
                </c:pt>
                <c:pt idx="242">
                  <c:v>1.19E-5</c:v>
                </c:pt>
                <c:pt idx="243">
                  <c:v>2.4900000000000002E-7</c:v>
                </c:pt>
                <c:pt idx="244">
                  <c:v>1.3300000000000001E-10</c:v>
                </c:pt>
                <c:pt idx="245">
                  <c:v>1.26E-9</c:v>
                </c:pt>
                <c:pt idx="246">
                  <c:v>9.3000000000000007E-6</c:v>
                </c:pt>
                <c:pt idx="247">
                  <c:v>1.6200000000000001E-10</c:v>
                </c:pt>
                <c:pt idx="248">
                  <c:v>3.5400000000000001E-13</c:v>
                </c:pt>
                <c:pt idx="249">
                  <c:v>5.5799999999999997E-11</c:v>
                </c:pt>
                <c:pt idx="250">
                  <c:v>2.1800000000000001E-13</c:v>
                </c:pt>
                <c:pt idx="251">
                  <c:v>4.6999999999999999E-6</c:v>
                </c:pt>
                <c:pt idx="252">
                  <c:v>2.4100000000000001E-8</c:v>
                </c:pt>
                <c:pt idx="253">
                  <c:v>8.8700000000000001E-11</c:v>
                </c:pt>
                <c:pt idx="254">
                  <c:v>2.0000000000000001E-9</c:v>
                </c:pt>
                <c:pt idx="255">
                  <c:v>1.19E-6</c:v>
                </c:pt>
                <c:pt idx="256">
                  <c:v>1.1700000000000001E-8</c:v>
                </c:pt>
                <c:pt idx="257">
                  <c:v>1.1200000000000001E-6</c:v>
                </c:pt>
                <c:pt idx="258">
                  <c:v>4.8299999999999997E-7</c:v>
                </c:pt>
                <c:pt idx="259">
                  <c:v>4.21E-8</c:v>
                </c:pt>
                <c:pt idx="260">
                  <c:v>1.24E-12</c:v>
                </c:pt>
                <c:pt idx="261">
                  <c:v>3.9199999999999997E-9</c:v>
                </c:pt>
                <c:pt idx="262">
                  <c:v>1.9799999999999999E-11</c:v>
                </c:pt>
                <c:pt idx="263">
                  <c:v>5.0200000000000002E-6</c:v>
                </c:pt>
                <c:pt idx="264">
                  <c:v>1.24E-5</c:v>
                </c:pt>
                <c:pt idx="265">
                  <c:v>1.4100000000000001E-6</c:v>
                </c:pt>
                <c:pt idx="266">
                  <c:v>8.8699999999999994E-8</c:v>
                </c:pt>
                <c:pt idx="267">
                  <c:v>1.06E-10</c:v>
                </c:pt>
                <c:pt idx="268">
                  <c:v>3.4499999999999999E-9</c:v>
                </c:pt>
                <c:pt idx="269">
                  <c:v>5.0600000000000001E-10</c:v>
                </c:pt>
                <c:pt idx="270">
                  <c:v>6.9800000000000003E-8</c:v>
                </c:pt>
                <c:pt idx="271">
                  <c:v>5.2000000000000002E-9</c:v>
                </c:pt>
                <c:pt idx="272">
                  <c:v>1.6399999999999999E-9</c:v>
                </c:pt>
                <c:pt idx="273">
                  <c:v>1.39E-9</c:v>
                </c:pt>
                <c:pt idx="274">
                  <c:v>5.3199999999999999E-5</c:v>
                </c:pt>
                <c:pt idx="275">
                  <c:v>4.7700000000000001E-5</c:v>
                </c:pt>
                <c:pt idx="276">
                  <c:v>9.5700000000000003E-8</c:v>
                </c:pt>
                <c:pt idx="277">
                  <c:v>2.09E-10</c:v>
                </c:pt>
                <c:pt idx="278">
                  <c:v>7.0999999999999998E-6</c:v>
                </c:pt>
                <c:pt idx="279">
                  <c:v>2.36E-8</c:v>
                </c:pt>
                <c:pt idx="280">
                  <c:v>8.9099999999999997E-5</c:v>
                </c:pt>
                <c:pt idx="281">
                  <c:v>5.1999999999999996E-10</c:v>
                </c:pt>
                <c:pt idx="282">
                  <c:v>1.3500000000000001E-9</c:v>
                </c:pt>
                <c:pt idx="283">
                  <c:v>4.1300000000000001E-5</c:v>
                </c:pt>
                <c:pt idx="284">
                  <c:v>2.84E-7</c:v>
                </c:pt>
                <c:pt idx="285">
                  <c:v>9.2500000000000001E-9</c:v>
                </c:pt>
                <c:pt idx="286">
                  <c:v>6.0800000000000002E-8</c:v>
                </c:pt>
                <c:pt idx="287">
                  <c:v>2.32E-4</c:v>
                </c:pt>
                <c:pt idx="288">
                  <c:v>1.15E-5</c:v>
                </c:pt>
                <c:pt idx="289">
                  <c:v>3.7499999999999999E-3</c:v>
                </c:pt>
                <c:pt idx="290">
                  <c:v>4.2299999999999997E-9</c:v>
                </c:pt>
                <c:pt idx="291">
                  <c:v>1.6000000000000001E-8</c:v>
                </c:pt>
                <c:pt idx="292">
                  <c:v>1.5400000000000001E-6</c:v>
                </c:pt>
                <c:pt idx="293">
                  <c:v>4.1199999999999999E-5</c:v>
                </c:pt>
                <c:pt idx="294">
                  <c:v>2.5100000000000001E-7</c:v>
                </c:pt>
                <c:pt idx="295">
                  <c:v>2.6599999999999999E-6</c:v>
                </c:pt>
                <c:pt idx="296">
                  <c:v>9.3999999999999994E-5</c:v>
                </c:pt>
                <c:pt idx="297">
                  <c:v>1.04E-7</c:v>
                </c:pt>
                <c:pt idx="298">
                  <c:v>1.58E-3</c:v>
                </c:pt>
                <c:pt idx="299">
                  <c:v>1.8500000000000001E-6</c:v>
                </c:pt>
                <c:pt idx="300">
                  <c:v>9.9299999999999998E-6</c:v>
                </c:pt>
                <c:pt idx="301">
                  <c:v>1.99E-7</c:v>
                </c:pt>
                <c:pt idx="302">
                  <c:v>4.4700000000000004E-6</c:v>
                </c:pt>
                <c:pt idx="303">
                  <c:v>3.1300000000000002E-5</c:v>
                </c:pt>
                <c:pt idx="304">
                  <c:v>5.4099999999999999E-6</c:v>
                </c:pt>
                <c:pt idx="305">
                  <c:v>3.4400000000000001E-4</c:v>
                </c:pt>
                <c:pt idx="306">
                  <c:v>1.73E-4</c:v>
                </c:pt>
                <c:pt idx="307">
                  <c:v>1.9799999999999999E-8</c:v>
                </c:pt>
                <c:pt idx="308">
                  <c:v>1.15E-3</c:v>
                </c:pt>
                <c:pt idx="309">
                  <c:v>1.56E-5</c:v>
                </c:pt>
                <c:pt idx="310">
                  <c:v>1.1400000000000001E-4</c:v>
                </c:pt>
                <c:pt idx="311">
                  <c:v>2.9799999999999998E-4</c:v>
                </c:pt>
                <c:pt idx="312">
                  <c:v>2.1299999999999999E-7</c:v>
                </c:pt>
                <c:pt idx="313">
                  <c:v>1.39E-8</c:v>
                </c:pt>
                <c:pt idx="314">
                  <c:v>2.1500000000000002E-6</c:v>
                </c:pt>
                <c:pt idx="315">
                  <c:v>1.0499999999999999E-6</c:v>
                </c:pt>
                <c:pt idx="316">
                  <c:v>3.0599999999999998E-5</c:v>
                </c:pt>
                <c:pt idx="317">
                  <c:v>3.1599999999999998E-6</c:v>
                </c:pt>
                <c:pt idx="318">
                  <c:v>1.0200000000000001E-5</c:v>
                </c:pt>
                <c:pt idx="319">
                  <c:v>4.3600000000000003E-5</c:v>
                </c:pt>
                <c:pt idx="320">
                  <c:v>3.5200000000000002E-5</c:v>
                </c:pt>
                <c:pt idx="321">
                  <c:v>6.7100000000000005E-5</c:v>
                </c:pt>
                <c:pt idx="322">
                  <c:v>7.7999999999999996E-3</c:v>
                </c:pt>
                <c:pt idx="323">
                  <c:v>1.12E-7</c:v>
                </c:pt>
                <c:pt idx="324">
                  <c:v>3.9799999999999998E-5</c:v>
                </c:pt>
                <c:pt idx="325">
                  <c:v>3.4799999999999999E-5</c:v>
                </c:pt>
                <c:pt idx="326">
                  <c:v>7.4800000000000002E-5</c:v>
                </c:pt>
                <c:pt idx="327">
                  <c:v>1.2200000000000001E-2</c:v>
                </c:pt>
                <c:pt idx="328">
                  <c:v>3.5300000000000002E-3</c:v>
                </c:pt>
                <c:pt idx="329">
                  <c:v>3.5599999999999998E-4</c:v>
                </c:pt>
                <c:pt idx="330">
                  <c:v>4.8799999999999999E-6</c:v>
                </c:pt>
                <c:pt idx="331">
                  <c:v>3.76E-6</c:v>
                </c:pt>
                <c:pt idx="332">
                  <c:v>2.1500000000000002E-6</c:v>
                </c:pt>
                <c:pt idx="333">
                  <c:v>4.4100000000000001E-5</c:v>
                </c:pt>
                <c:pt idx="334">
                  <c:v>1.77E-5</c:v>
                </c:pt>
                <c:pt idx="335">
                  <c:v>3.3300000000000001E-3</c:v>
                </c:pt>
                <c:pt idx="336">
                  <c:v>7.5499999999999997E-6</c:v>
                </c:pt>
                <c:pt idx="337">
                  <c:v>1.9800000000000001E-6</c:v>
                </c:pt>
                <c:pt idx="338">
                  <c:v>5.4500000000000003E-6</c:v>
                </c:pt>
                <c:pt idx="339">
                  <c:v>5.2399999999999999E-3</c:v>
                </c:pt>
                <c:pt idx="340">
                  <c:v>8.0900000000000004E-4</c:v>
                </c:pt>
                <c:pt idx="341">
                  <c:v>1.4599999999999999E-3</c:v>
                </c:pt>
                <c:pt idx="342">
                  <c:v>2.0699999999999998E-3</c:v>
                </c:pt>
                <c:pt idx="343">
                  <c:v>5.8200000000000005E-4</c:v>
                </c:pt>
                <c:pt idx="344">
                  <c:v>1.0200000000000001E-2</c:v>
                </c:pt>
                <c:pt idx="345">
                  <c:v>1.21E-2</c:v>
                </c:pt>
                <c:pt idx="346">
                  <c:v>3.5200000000000002E-6</c:v>
                </c:pt>
                <c:pt idx="347">
                  <c:v>4.47E-3</c:v>
                </c:pt>
                <c:pt idx="348">
                  <c:v>9.0699999999999996E-5</c:v>
                </c:pt>
                <c:pt idx="349">
                  <c:v>2.8699999999999998E-4</c:v>
                </c:pt>
                <c:pt idx="350">
                  <c:v>2.9099999999999999E-5</c:v>
                </c:pt>
                <c:pt idx="351">
                  <c:v>2.4600000000000002E-4</c:v>
                </c:pt>
                <c:pt idx="352">
                  <c:v>5.8500000000000002E-3</c:v>
                </c:pt>
                <c:pt idx="353">
                  <c:v>2.55E-5</c:v>
                </c:pt>
                <c:pt idx="354">
                  <c:v>2.65E-3</c:v>
                </c:pt>
                <c:pt idx="355">
                  <c:v>3.2499999999999997E-5</c:v>
                </c:pt>
                <c:pt idx="356">
                  <c:v>2.7200000000000002E-3</c:v>
                </c:pt>
                <c:pt idx="357">
                  <c:v>1.76E-4</c:v>
                </c:pt>
                <c:pt idx="358">
                  <c:v>3.0899999999999998E-4</c:v>
                </c:pt>
                <c:pt idx="359">
                  <c:v>3.1399999999999998E-5</c:v>
                </c:pt>
                <c:pt idx="360">
                  <c:v>1.9000000000000001E-4</c:v>
                </c:pt>
                <c:pt idx="361">
                  <c:v>6.9499999999999995E-5</c:v>
                </c:pt>
                <c:pt idx="362">
                  <c:v>2.69E-5</c:v>
                </c:pt>
                <c:pt idx="363">
                  <c:v>2.2599999999999999E-3</c:v>
                </c:pt>
                <c:pt idx="364">
                  <c:v>4.3399999999999998E-5</c:v>
                </c:pt>
                <c:pt idx="365">
                  <c:v>1.13E-4</c:v>
                </c:pt>
                <c:pt idx="366">
                  <c:v>2.0400000000000001E-3</c:v>
                </c:pt>
                <c:pt idx="367">
                  <c:v>1.35E-4</c:v>
                </c:pt>
                <c:pt idx="368">
                  <c:v>3.0699999999999998E-3</c:v>
                </c:pt>
                <c:pt idx="369">
                  <c:v>2.2800000000000001E-4</c:v>
                </c:pt>
                <c:pt idx="370">
                  <c:v>7.4000000000000003E-3</c:v>
                </c:pt>
                <c:pt idx="371">
                  <c:v>1.65E-4</c:v>
                </c:pt>
                <c:pt idx="372">
                  <c:v>1.2899999999999999E-3</c:v>
                </c:pt>
                <c:pt idx="373">
                  <c:v>2.2300000000000002E-3</c:v>
                </c:pt>
                <c:pt idx="374">
                  <c:v>6.6799999999999997E-5</c:v>
                </c:pt>
                <c:pt idx="375">
                  <c:v>1.17E-3</c:v>
                </c:pt>
                <c:pt idx="376">
                  <c:v>8.5699999999999996E-5</c:v>
                </c:pt>
                <c:pt idx="377">
                  <c:v>6.1000000000000004E-3</c:v>
                </c:pt>
                <c:pt idx="378">
                  <c:v>4.4299999999999998E-4</c:v>
                </c:pt>
                <c:pt idx="379">
                  <c:v>2.0400000000000001E-3</c:v>
                </c:pt>
                <c:pt idx="380">
                  <c:v>6.1600000000000001E-4</c:v>
                </c:pt>
                <c:pt idx="381">
                  <c:v>1.2700000000000001E-3</c:v>
                </c:pt>
                <c:pt idx="382">
                  <c:v>3.19E-4</c:v>
                </c:pt>
                <c:pt idx="383">
                  <c:v>7.1900000000000002E-3</c:v>
                </c:pt>
                <c:pt idx="384">
                  <c:v>9.41E-4</c:v>
                </c:pt>
                <c:pt idx="385">
                  <c:v>1.3999999999999999E-4</c:v>
                </c:pt>
                <c:pt idx="386">
                  <c:v>1.06E-3</c:v>
                </c:pt>
                <c:pt idx="387">
                  <c:v>1E-3</c:v>
                </c:pt>
                <c:pt idx="388">
                  <c:v>6.6799999999999997E-4</c:v>
                </c:pt>
                <c:pt idx="389">
                  <c:v>4.4200000000000003E-3</c:v>
                </c:pt>
                <c:pt idx="390">
                  <c:v>1.5100000000000001E-4</c:v>
                </c:pt>
                <c:pt idx="391">
                  <c:v>1.7100000000000001E-4</c:v>
                </c:pt>
                <c:pt idx="392">
                  <c:v>2.4399999999999999E-3</c:v>
                </c:pt>
                <c:pt idx="393">
                  <c:v>8.3699999999999996E-4</c:v>
                </c:pt>
                <c:pt idx="394">
                  <c:v>3.4200000000000002E-4</c:v>
                </c:pt>
                <c:pt idx="395">
                  <c:v>2.1699999999999999E-4</c:v>
                </c:pt>
                <c:pt idx="396">
                  <c:v>1.2E-2</c:v>
                </c:pt>
                <c:pt idx="397">
                  <c:v>5.6600000000000001E-3</c:v>
                </c:pt>
                <c:pt idx="398">
                  <c:v>3.8400000000000001E-3</c:v>
                </c:pt>
                <c:pt idx="399">
                  <c:v>2.99E-4</c:v>
                </c:pt>
                <c:pt idx="400">
                  <c:v>5.0500000000000002E-4</c:v>
                </c:pt>
                <c:pt idx="401">
                  <c:v>1.5900000000000001E-3</c:v>
                </c:pt>
                <c:pt idx="402">
                  <c:v>9.4699999999999993E-3</c:v>
                </c:pt>
                <c:pt idx="403">
                  <c:v>1.8699999999999999E-3</c:v>
                </c:pt>
                <c:pt idx="404">
                  <c:v>7.3200000000000001E-4</c:v>
                </c:pt>
                <c:pt idx="405">
                  <c:v>3.6000000000000002E-4</c:v>
                </c:pt>
                <c:pt idx="406">
                  <c:v>3.2299999999999998E-3</c:v>
                </c:pt>
                <c:pt idx="407">
                  <c:v>1.0300000000000001E-3</c:v>
                </c:pt>
                <c:pt idx="408">
                  <c:v>3.2000000000000002E-3</c:v>
                </c:pt>
                <c:pt idx="409">
                  <c:v>1.32E-2</c:v>
                </c:pt>
                <c:pt idx="410">
                  <c:v>6.8999999999999999E-3</c:v>
                </c:pt>
                <c:pt idx="411">
                  <c:v>5.9699999999999996E-3</c:v>
                </c:pt>
                <c:pt idx="412">
                  <c:v>7.0799999999999997E-4</c:v>
                </c:pt>
                <c:pt idx="413">
                  <c:v>1.01E-2</c:v>
                </c:pt>
                <c:pt idx="414">
                  <c:v>5.3400000000000001E-3</c:v>
                </c:pt>
                <c:pt idx="415">
                  <c:v>7.2700000000000004E-3</c:v>
                </c:pt>
                <c:pt idx="416">
                  <c:v>8.1600000000000006E-3</c:v>
                </c:pt>
                <c:pt idx="417">
                  <c:v>1.34E-2</c:v>
                </c:pt>
                <c:pt idx="418">
                  <c:v>6.0000000000000001E-3</c:v>
                </c:pt>
                <c:pt idx="419">
                  <c:v>1.3599999999999999E-2</c:v>
                </c:pt>
                <c:pt idx="420">
                  <c:v>3.9500000000000004E-3</c:v>
                </c:pt>
                <c:pt idx="421">
                  <c:v>1.5499999999999999E-3</c:v>
                </c:pt>
                <c:pt idx="422">
                  <c:v>8.1499999999999993E-3</c:v>
                </c:pt>
                <c:pt idx="423">
                  <c:v>6.6E-3</c:v>
                </c:pt>
                <c:pt idx="424">
                  <c:v>2.3800000000000002E-3</c:v>
                </c:pt>
                <c:pt idx="425">
                  <c:v>1.07E-3</c:v>
                </c:pt>
                <c:pt idx="426">
                  <c:v>1.5299999999999999E-3</c:v>
                </c:pt>
                <c:pt idx="427">
                  <c:v>1.31E-3</c:v>
                </c:pt>
                <c:pt idx="428">
                  <c:v>2.1099999999999999E-3</c:v>
                </c:pt>
                <c:pt idx="429">
                  <c:v>4.3200000000000001E-3</c:v>
                </c:pt>
                <c:pt idx="430">
                  <c:v>2.8E-3</c:v>
                </c:pt>
                <c:pt idx="431">
                  <c:v>1.5200000000000001E-3</c:v>
                </c:pt>
                <c:pt idx="432">
                  <c:v>4.7699999999999999E-3</c:v>
                </c:pt>
                <c:pt idx="433">
                  <c:v>2.8999999999999998E-3</c:v>
                </c:pt>
                <c:pt idx="434">
                  <c:v>4.2599999999999999E-3</c:v>
                </c:pt>
                <c:pt idx="435">
                  <c:v>1.2999999999999999E-2</c:v>
                </c:pt>
                <c:pt idx="436">
                  <c:v>6.0200000000000002E-3</c:v>
                </c:pt>
                <c:pt idx="437">
                  <c:v>1.2699999999999999E-2</c:v>
                </c:pt>
                <c:pt idx="438">
                  <c:v>2.6199999999999999E-3</c:v>
                </c:pt>
                <c:pt idx="439">
                  <c:v>2.2000000000000001E-3</c:v>
                </c:pt>
                <c:pt idx="440">
                  <c:v>4.2500000000000003E-3</c:v>
                </c:pt>
                <c:pt idx="441">
                  <c:v>6.3899999999999998E-3</c:v>
                </c:pt>
                <c:pt idx="442">
                  <c:v>9.7000000000000003E-3</c:v>
                </c:pt>
                <c:pt idx="443">
                  <c:v>1.0800000000000001E-2</c:v>
                </c:pt>
                <c:pt idx="444">
                  <c:v>9.7000000000000003E-3</c:v>
                </c:pt>
                <c:pt idx="445">
                  <c:v>9.3600000000000003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038456"/>
        <c:axId val="136601912"/>
      </c:scatterChart>
      <c:valAx>
        <c:axId val="181038456"/>
        <c:scaling>
          <c:orientation val="minMax"/>
        </c:scaling>
        <c:delete val="0"/>
        <c:axPos val="t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6601912"/>
        <c:crosses val="autoZero"/>
        <c:crossBetween val="midCat"/>
        <c:majorUnit val="2"/>
      </c:valAx>
      <c:valAx>
        <c:axId val="136601912"/>
        <c:scaling>
          <c:logBase val="10"/>
          <c:orientation val="maxMin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0384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7227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4813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428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5524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0004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636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358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296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0319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3487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928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8262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-111081" y="2112898"/>
            <a:ext cx="911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p</a:t>
            </a:r>
            <a:r>
              <a:rPr lang="en-AU" sz="1200" dirty="0" smtClean="0"/>
              <a:t> value</a:t>
            </a:r>
            <a:endParaRPr lang="en-AU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770939" y="3869432"/>
            <a:ext cx="2826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Log</a:t>
            </a:r>
            <a:r>
              <a:rPr lang="en-AU" sz="1200" baseline="-25000" dirty="0" smtClean="0"/>
              <a:t>2</a:t>
            </a:r>
            <a:r>
              <a:rPr lang="en-AU" sz="1200" dirty="0" smtClean="0"/>
              <a:t>fold change </a:t>
            </a:r>
            <a:r>
              <a:rPr lang="en-AU" sz="1200" i="1" dirty="0" smtClean="0"/>
              <a:t>in planta </a:t>
            </a:r>
            <a:r>
              <a:rPr lang="en-AU" sz="1200" dirty="0" smtClean="0"/>
              <a:t>vs </a:t>
            </a:r>
            <a:r>
              <a:rPr lang="en-AU" sz="1200" i="1" dirty="0" smtClean="0"/>
              <a:t>in vitro</a:t>
            </a:r>
            <a:endParaRPr lang="en-AU" sz="1200" i="1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0460658"/>
              </p:ext>
            </p:extLst>
          </p:nvPr>
        </p:nvGraphicFramePr>
        <p:xfrm>
          <a:off x="415715" y="815716"/>
          <a:ext cx="3222471" cy="3110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0219269"/>
              </p:ext>
            </p:extLst>
          </p:nvPr>
        </p:nvGraphicFramePr>
        <p:xfrm>
          <a:off x="3579422" y="815716"/>
          <a:ext cx="3278578" cy="3110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8" name="Straight Connector 7"/>
          <p:cNvCxnSpPr/>
          <p:nvPr/>
        </p:nvCxnSpPr>
        <p:spPr>
          <a:xfrm>
            <a:off x="1825198" y="954215"/>
            <a:ext cx="6988" cy="2671848"/>
          </a:xfrm>
          <a:prstGeom prst="line">
            <a:avLst/>
          </a:prstGeom>
          <a:ln w="127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4798825" y="954214"/>
            <a:ext cx="619" cy="2671849"/>
          </a:xfrm>
          <a:prstGeom prst="line">
            <a:avLst/>
          </a:prstGeom>
          <a:ln w="127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06165" y="672841"/>
            <a:ext cx="297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/>
              <a:t>A</a:t>
            </a:r>
            <a:endParaRPr lang="en-AU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721727" y="677216"/>
            <a:ext cx="156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DZA315  2dpi vs IV</a:t>
            </a:r>
            <a:endParaRPr lang="en-AU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3725738" y="677215"/>
            <a:ext cx="156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A17  2dpi vs IV</a:t>
            </a:r>
            <a:endParaRPr lang="en-AU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3858245" y="3866623"/>
            <a:ext cx="2826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Log</a:t>
            </a:r>
            <a:r>
              <a:rPr lang="en-AU" sz="1200" baseline="-25000" dirty="0" smtClean="0"/>
              <a:t>2</a:t>
            </a:r>
            <a:r>
              <a:rPr lang="en-AU" sz="1200" dirty="0" smtClean="0"/>
              <a:t>fold change </a:t>
            </a:r>
            <a:r>
              <a:rPr lang="en-AU" sz="1200" i="1" dirty="0" smtClean="0"/>
              <a:t>in planta </a:t>
            </a:r>
            <a:r>
              <a:rPr lang="en-AU" sz="1200" dirty="0" smtClean="0"/>
              <a:t>vs </a:t>
            </a:r>
            <a:r>
              <a:rPr lang="en-AU" sz="1200" i="1" dirty="0" smtClean="0"/>
              <a:t>in vitro</a:t>
            </a:r>
            <a:endParaRPr lang="en-AU" sz="1200" i="1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23934"/>
              </p:ext>
            </p:extLst>
          </p:nvPr>
        </p:nvGraphicFramePr>
        <p:xfrm>
          <a:off x="3476405" y="4617888"/>
          <a:ext cx="3347774" cy="30707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3735263" y="4468368"/>
            <a:ext cx="156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A17  7dpi vs IV</a:t>
            </a:r>
            <a:endParaRPr lang="en-AU" sz="1200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9248624"/>
              </p:ext>
            </p:extLst>
          </p:nvPr>
        </p:nvGraphicFramePr>
        <p:xfrm>
          <a:off x="197721" y="4603786"/>
          <a:ext cx="3399230" cy="3084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215690" y="4454266"/>
            <a:ext cx="297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/>
              <a:t>B</a:t>
            </a:r>
            <a:endParaRPr lang="en-AU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731252" y="4458641"/>
            <a:ext cx="156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DZA315  7dpi vs IV</a:t>
            </a:r>
            <a:endParaRPr lang="en-AU" sz="12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-101556" y="5894323"/>
            <a:ext cx="911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p</a:t>
            </a:r>
            <a:r>
              <a:rPr lang="en-AU" sz="1200" dirty="0" smtClean="0"/>
              <a:t> value</a:t>
            </a:r>
            <a:endParaRPr lang="en-AU" sz="1200" dirty="0"/>
          </a:p>
        </p:txBody>
      </p:sp>
      <p:cxnSp>
        <p:nvCxnSpPr>
          <p:cNvPr id="38" name="Straight Connector 37"/>
          <p:cNvCxnSpPr/>
          <p:nvPr/>
        </p:nvCxnSpPr>
        <p:spPr>
          <a:xfrm flipH="1">
            <a:off x="1350173" y="4731778"/>
            <a:ext cx="6824" cy="2671848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749403" y="4759469"/>
            <a:ext cx="14276" cy="2650981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796575" y="7585530"/>
            <a:ext cx="2826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Log</a:t>
            </a:r>
            <a:r>
              <a:rPr lang="en-AU" sz="1200" baseline="-25000" dirty="0" smtClean="0"/>
              <a:t>2</a:t>
            </a:r>
            <a:r>
              <a:rPr lang="en-AU" sz="1200" dirty="0" smtClean="0"/>
              <a:t>fold change </a:t>
            </a:r>
            <a:r>
              <a:rPr lang="en-AU" sz="1200" i="1" dirty="0" smtClean="0"/>
              <a:t>in planta </a:t>
            </a:r>
            <a:r>
              <a:rPr lang="en-AU" sz="1200" dirty="0" smtClean="0"/>
              <a:t>vs </a:t>
            </a:r>
            <a:r>
              <a:rPr lang="en-AU" sz="1200" i="1" dirty="0" smtClean="0"/>
              <a:t>in vitro</a:t>
            </a:r>
            <a:endParaRPr lang="en-AU" sz="1200" i="1" dirty="0"/>
          </a:p>
        </p:txBody>
      </p:sp>
      <p:sp>
        <p:nvSpPr>
          <p:cNvPr id="42" name="TextBox 41"/>
          <p:cNvSpPr txBox="1"/>
          <p:nvPr/>
        </p:nvSpPr>
        <p:spPr>
          <a:xfrm>
            <a:off x="3883881" y="7582721"/>
            <a:ext cx="2826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Log</a:t>
            </a:r>
            <a:r>
              <a:rPr lang="en-AU" sz="1200" baseline="-25000" dirty="0" smtClean="0"/>
              <a:t>2</a:t>
            </a:r>
            <a:r>
              <a:rPr lang="en-AU" sz="1200" dirty="0" smtClean="0"/>
              <a:t>fold change </a:t>
            </a:r>
            <a:r>
              <a:rPr lang="en-AU" sz="1200" i="1" dirty="0" smtClean="0"/>
              <a:t>in planta </a:t>
            </a:r>
            <a:r>
              <a:rPr lang="en-AU" sz="1200" dirty="0" smtClean="0"/>
              <a:t>vs </a:t>
            </a:r>
            <a:r>
              <a:rPr lang="en-AU" sz="1200" i="1" dirty="0" smtClean="0"/>
              <a:t>in vitro</a:t>
            </a:r>
            <a:endParaRPr lang="en-AU" sz="1200" i="1" dirty="0"/>
          </a:p>
        </p:txBody>
      </p:sp>
      <p:sp>
        <p:nvSpPr>
          <p:cNvPr id="25" name="TextBox 7"/>
          <p:cNvSpPr txBox="1"/>
          <p:nvPr/>
        </p:nvSpPr>
        <p:spPr>
          <a:xfrm>
            <a:off x="364610" y="8125593"/>
            <a:ext cx="63196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69382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38764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808147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77529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346911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616293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85676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155058" algn="l" defTabSz="538764" rtl="0" eaLnBrk="1" latinLnBrk="0" hangingPunct="1">
              <a:defRPr sz="106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AU" sz="1200" b="1" dirty="0" smtClean="0">
                <a:cs typeface="Arial" panose="020B0604020202020204" pitchFamily="34" charset="0"/>
              </a:rPr>
              <a:t>Additional file </a:t>
            </a:r>
            <a:r>
              <a:rPr lang="en-AU" sz="1200" b="1" dirty="0">
                <a:cs typeface="Arial" panose="020B0604020202020204" pitchFamily="34" charset="0"/>
              </a:rPr>
              <a:t>7</a:t>
            </a:r>
            <a:r>
              <a:rPr lang="en-AU" sz="1200" b="1" dirty="0" smtClean="0">
                <a:cs typeface="Arial" panose="020B0604020202020204" pitchFamily="34" charset="0"/>
              </a:rPr>
              <a:t>. </a:t>
            </a:r>
            <a:r>
              <a:rPr lang="en-AU" sz="1200" b="1" dirty="0" smtClean="0"/>
              <a:t>Plots </a:t>
            </a:r>
            <a:r>
              <a:rPr lang="en-AU" sz="1200" b="1" dirty="0"/>
              <a:t>of DEG significance versus in planta up-regulated fold induction.</a:t>
            </a:r>
            <a:endParaRPr lang="en-AU" sz="1200" dirty="0"/>
          </a:p>
          <a:p>
            <a:pPr algn="just"/>
            <a:r>
              <a:rPr lang="en-AU" sz="1200" dirty="0"/>
              <a:t>A) 2 dpi datasets. B) 7 dpi datasets. Each circle represents a DEG with predicted small secreted proteins noted in red. The red line in each graph depicts the log2fold change at which 50% or greater of the DEGs were induced in planta versus </a:t>
            </a:r>
            <a:r>
              <a:rPr lang="en-AU" sz="1200" i="1" dirty="0"/>
              <a:t>in vitro</a:t>
            </a:r>
            <a:r>
              <a:rPr lang="en-AU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990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67</TotalTime>
  <Words>118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tcher, Louise (Agriculture, Floreat)</dc:creator>
  <cp:lastModifiedBy>Thatcher, Louise (Agriculture, Floreat)</cp:lastModifiedBy>
  <cp:revision>137</cp:revision>
  <cp:lastPrinted>2016-06-03T09:23:52Z</cp:lastPrinted>
  <dcterms:created xsi:type="dcterms:W3CDTF">2016-01-07T06:49:03Z</dcterms:created>
  <dcterms:modified xsi:type="dcterms:W3CDTF">2016-07-22T02:15:37Z</dcterms:modified>
</cp:coreProperties>
</file>